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  <p:sldId id="263" r:id="rId3"/>
    <p:sldId id="256" r:id="rId4"/>
    <p:sldId id="258" r:id="rId5"/>
    <p:sldId id="257" r:id="rId6"/>
    <p:sldId id="259" r:id="rId7"/>
    <p:sldId id="260" r:id="rId8"/>
    <p:sldId id="261" r:id="rId9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2" autoAdjust="0"/>
    <p:restoredTop sz="94660"/>
  </p:normalViewPr>
  <p:slideViewPr>
    <p:cSldViewPr snapToGrid="0">
      <p:cViewPr varScale="1">
        <p:scale>
          <a:sx n="79" d="100"/>
          <a:sy n="79" d="100"/>
        </p:scale>
        <p:origin x="280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A84096-D503-403C-88F2-BB523E5F6093}" type="datetimeFigureOut">
              <a:rPr lang="en-US" smtClean="0"/>
              <a:t>3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014184-ADBA-4C32-BECA-3DA75C6E3A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99975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A84096-D503-403C-88F2-BB523E5F6093}" type="datetimeFigureOut">
              <a:rPr lang="en-US" smtClean="0"/>
              <a:t>3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014184-ADBA-4C32-BECA-3DA75C6E3A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88590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A84096-D503-403C-88F2-BB523E5F6093}" type="datetimeFigureOut">
              <a:rPr lang="en-US" smtClean="0"/>
              <a:t>3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014184-ADBA-4C32-BECA-3DA75C6E3A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06511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A84096-D503-403C-88F2-BB523E5F6093}" type="datetimeFigureOut">
              <a:rPr lang="en-US" smtClean="0"/>
              <a:t>3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014184-ADBA-4C32-BECA-3DA75C6E3A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74498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A84096-D503-403C-88F2-BB523E5F6093}" type="datetimeFigureOut">
              <a:rPr lang="en-US" smtClean="0"/>
              <a:t>3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014184-ADBA-4C32-BECA-3DA75C6E3A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66923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A84096-D503-403C-88F2-BB523E5F6093}" type="datetimeFigureOut">
              <a:rPr lang="en-US" smtClean="0"/>
              <a:t>3/1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014184-ADBA-4C32-BECA-3DA75C6E3A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16059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A84096-D503-403C-88F2-BB523E5F6093}" type="datetimeFigureOut">
              <a:rPr lang="en-US" smtClean="0"/>
              <a:t>3/16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014184-ADBA-4C32-BECA-3DA75C6E3A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88897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A84096-D503-403C-88F2-BB523E5F6093}" type="datetimeFigureOut">
              <a:rPr lang="en-US" smtClean="0"/>
              <a:t>3/16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014184-ADBA-4C32-BECA-3DA75C6E3A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72125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A84096-D503-403C-88F2-BB523E5F6093}" type="datetimeFigureOut">
              <a:rPr lang="en-US" smtClean="0"/>
              <a:t>3/16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014184-ADBA-4C32-BECA-3DA75C6E3A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24915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A84096-D503-403C-88F2-BB523E5F6093}" type="datetimeFigureOut">
              <a:rPr lang="en-US" smtClean="0"/>
              <a:t>3/1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014184-ADBA-4C32-BECA-3DA75C6E3A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40406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A84096-D503-403C-88F2-BB523E5F6093}" type="datetimeFigureOut">
              <a:rPr lang="en-US" smtClean="0"/>
              <a:t>3/1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014184-ADBA-4C32-BECA-3DA75C6E3A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10663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A84096-D503-403C-88F2-BB523E5F6093}" type="datetimeFigureOut">
              <a:rPr lang="en-US" smtClean="0"/>
              <a:t>3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014184-ADBA-4C32-BECA-3DA75C6E3A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50217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280" y="184404"/>
            <a:ext cx="7101840" cy="9689592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0" y="0"/>
            <a:ext cx="56959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1</a:t>
            </a:r>
            <a:r>
              <a:rPr lang="en-US" dirty="0" smtClean="0"/>
              <a:t> Behavioral measures and example traces</a:t>
            </a:r>
            <a:endParaRPr lang="en-US" dirty="0"/>
          </a:p>
        </p:txBody>
      </p:sp>
      <p:sp>
        <p:nvSpPr>
          <p:cNvPr id="2" name="TextBox 1"/>
          <p:cNvSpPr txBox="1"/>
          <p:nvPr/>
        </p:nvSpPr>
        <p:spPr>
          <a:xfrm>
            <a:off x="6169152" y="2328672"/>
            <a:ext cx="138379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Mean and SEM lines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604623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524" y="2270760"/>
            <a:ext cx="7007352" cy="551688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81000" y="304800"/>
            <a:ext cx="42100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2</a:t>
            </a:r>
            <a:r>
              <a:rPr lang="en-US" dirty="0" smtClean="0"/>
              <a:t> Example ROIs overlaid on slice images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492638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1820964" y="4729672"/>
            <a:ext cx="3609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W</a:t>
            </a:r>
            <a:endParaRPr lang="en-US" dirty="0"/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00849704"/>
              </p:ext>
            </p:extLst>
          </p:nvPr>
        </p:nvGraphicFramePr>
        <p:xfrm>
          <a:off x="1329489" y="463550"/>
          <a:ext cx="6226337" cy="421995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78949">
                  <a:extLst>
                    <a:ext uri="{9D8B030D-6E8A-4147-A177-3AD203B41FA5}">
                      <a16:colId xmlns:a16="http://schemas.microsoft.com/office/drawing/2014/main" val="3299955168"/>
                    </a:ext>
                  </a:extLst>
                </a:gridCol>
                <a:gridCol w="478949">
                  <a:extLst>
                    <a:ext uri="{9D8B030D-6E8A-4147-A177-3AD203B41FA5}">
                      <a16:colId xmlns:a16="http://schemas.microsoft.com/office/drawing/2014/main" val="3518428553"/>
                    </a:ext>
                  </a:extLst>
                </a:gridCol>
                <a:gridCol w="478949">
                  <a:extLst>
                    <a:ext uri="{9D8B030D-6E8A-4147-A177-3AD203B41FA5}">
                      <a16:colId xmlns:a16="http://schemas.microsoft.com/office/drawing/2014/main" val="1500847331"/>
                    </a:ext>
                  </a:extLst>
                </a:gridCol>
                <a:gridCol w="478949">
                  <a:extLst>
                    <a:ext uri="{9D8B030D-6E8A-4147-A177-3AD203B41FA5}">
                      <a16:colId xmlns:a16="http://schemas.microsoft.com/office/drawing/2014/main" val="1046276668"/>
                    </a:ext>
                  </a:extLst>
                </a:gridCol>
                <a:gridCol w="478949">
                  <a:extLst>
                    <a:ext uri="{9D8B030D-6E8A-4147-A177-3AD203B41FA5}">
                      <a16:colId xmlns:a16="http://schemas.microsoft.com/office/drawing/2014/main" val="1328205229"/>
                    </a:ext>
                  </a:extLst>
                </a:gridCol>
                <a:gridCol w="478949">
                  <a:extLst>
                    <a:ext uri="{9D8B030D-6E8A-4147-A177-3AD203B41FA5}">
                      <a16:colId xmlns:a16="http://schemas.microsoft.com/office/drawing/2014/main" val="2328748899"/>
                    </a:ext>
                  </a:extLst>
                </a:gridCol>
                <a:gridCol w="478949">
                  <a:extLst>
                    <a:ext uri="{9D8B030D-6E8A-4147-A177-3AD203B41FA5}">
                      <a16:colId xmlns:a16="http://schemas.microsoft.com/office/drawing/2014/main" val="3436891428"/>
                    </a:ext>
                  </a:extLst>
                </a:gridCol>
                <a:gridCol w="478949">
                  <a:extLst>
                    <a:ext uri="{9D8B030D-6E8A-4147-A177-3AD203B41FA5}">
                      <a16:colId xmlns:a16="http://schemas.microsoft.com/office/drawing/2014/main" val="2651438799"/>
                    </a:ext>
                  </a:extLst>
                </a:gridCol>
                <a:gridCol w="478949">
                  <a:extLst>
                    <a:ext uri="{9D8B030D-6E8A-4147-A177-3AD203B41FA5}">
                      <a16:colId xmlns:a16="http://schemas.microsoft.com/office/drawing/2014/main" val="1075142996"/>
                    </a:ext>
                  </a:extLst>
                </a:gridCol>
                <a:gridCol w="478949">
                  <a:extLst>
                    <a:ext uri="{9D8B030D-6E8A-4147-A177-3AD203B41FA5}">
                      <a16:colId xmlns:a16="http://schemas.microsoft.com/office/drawing/2014/main" val="97787227"/>
                    </a:ext>
                  </a:extLst>
                </a:gridCol>
                <a:gridCol w="478949">
                  <a:extLst>
                    <a:ext uri="{9D8B030D-6E8A-4147-A177-3AD203B41FA5}">
                      <a16:colId xmlns:a16="http://schemas.microsoft.com/office/drawing/2014/main" val="3029488972"/>
                    </a:ext>
                  </a:extLst>
                </a:gridCol>
                <a:gridCol w="478949">
                  <a:extLst>
                    <a:ext uri="{9D8B030D-6E8A-4147-A177-3AD203B41FA5}">
                      <a16:colId xmlns:a16="http://schemas.microsoft.com/office/drawing/2014/main" val="4006442000"/>
                    </a:ext>
                  </a:extLst>
                </a:gridCol>
                <a:gridCol w="478949">
                  <a:extLst>
                    <a:ext uri="{9D8B030D-6E8A-4147-A177-3AD203B41FA5}">
                      <a16:colId xmlns:a16="http://schemas.microsoft.com/office/drawing/2014/main" val="4158743848"/>
                    </a:ext>
                  </a:extLst>
                </a:gridCol>
              </a:tblGrid>
              <a:tr h="298450">
                <a:tc>
                  <a:txBody>
                    <a:bodyPr/>
                    <a:lstStyle/>
                    <a:p>
                      <a:r>
                        <a:rPr lang="en-US" dirty="0" smtClean="0"/>
                        <a:t>Sal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72316972"/>
                  </a:ext>
                </a:extLst>
              </a:tr>
              <a:tr h="298450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41894299"/>
                  </a:ext>
                </a:extLst>
              </a:tr>
              <a:tr h="298450"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32</a:t>
                      </a: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7888228"/>
                  </a:ext>
                </a:extLst>
              </a:tr>
              <a:tr h="298450"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11666566"/>
                  </a:ext>
                </a:extLst>
              </a:tr>
              <a:tr h="298450"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95764914"/>
                  </a:ext>
                </a:extLst>
              </a:tr>
              <a:tr h="298450"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01016193"/>
                  </a:ext>
                </a:extLst>
              </a:tr>
              <a:tr h="298450"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16485380"/>
                  </a:ext>
                </a:extLst>
              </a:tr>
              <a:tr h="298450"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2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517858"/>
                  </a:ext>
                </a:extLst>
              </a:tr>
              <a:tr h="298450"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71920974"/>
                  </a:ext>
                </a:extLst>
              </a:tr>
              <a:tr h="298450"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81</a:t>
                      </a: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1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54130650"/>
                  </a:ext>
                </a:extLst>
              </a:tr>
              <a:tr h="298450"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33414060"/>
                  </a:ext>
                </a:extLst>
              </a:tr>
              <a:tr h="298450"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83984466"/>
                  </a:ext>
                </a:extLst>
              </a:tr>
              <a:tr h="298450"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06536532"/>
                  </a:ext>
                </a:extLst>
              </a:tr>
            </a:tbl>
          </a:graphicData>
        </a:graphic>
      </p:graphicFrame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67630889"/>
              </p:ext>
            </p:extLst>
          </p:nvPr>
        </p:nvGraphicFramePr>
        <p:xfrm>
          <a:off x="1329489" y="5166181"/>
          <a:ext cx="6226337" cy="428758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78949">
                  <a:extLst>
                    <a:ext uri="{9D8B030D-6E8A-4147-A177-3AD203B41FA5}">
                      <a16:colId xmlns:a16="http://schemas.microsoft.com/office/drawing/2014/main" val="2727874154"/>
                    </a:ext>
                  </a:extLst>
                </a:gridCol>
                <a:gridCol w="478949">
                  <a:extLst>
                    <a:ext uri="{9D8B030D-6E8A-4147-A177-3AD203B41FA5}">
                      <a16:colId xmlns:a16="http://schemas.microsoft.com/office/drawing/2014/main" val="2777533725"/>
                    </a:ext>
                  </a:extLst>
                </a:gridCol>
                <a:gridCol w="478949">
                  <a:extLst>
                    <a:ext uri="{9D8B030D-6E8A-4147-A177-3AD203B41FA5}">
                      <a16:colId xmlns:a16="http://schemas.microsoft.com/office/drawing/2014/main" val="1951883307"/>
                    </a:ext>
                  </a:extLst>
                </a:gridCol>
                <a:gridCol w="478949">
                  <a:extLst>
                    <a:ext uri="{9D8B030D-6E8A-4147-A177-3AD203B41FA5}">
                      <a16:colId xmlns:a16="http://schemas.microsoft.com/office/drawing/2014/main" val="1108558905"/>
                    </a:ext>
                  </a:extLst>
                </a:gridCol>
                <a:gridCol w="478949">
                  <a:extLst>
                    <a:ext uri="{9D8B030D-6E8A-4147-A177-3AD203B41FA5}">
                      <a16:colId xmlns:a16="http://schemas.microsoft.com/office/drawing/2014/main" val="167203435"/>
                    </a:ext>
                  </a:extLst>
                </a:gridCol>
                <a:gridCol w="478949">
                  <a:extLst>
                    <a:ext uri="{9D8B030D-6E8A-4147-A177-3AD203B41FA5}">
                      <a16:colId xmlns:a16="http://schemas.microsoft.com/office/drawing/2014/main" val="4155376928"/>
                    </a:ext>
                  </a:extLst>
                </a:gridCol>
                <a:gridCol w="478949">
                  <a:extLst>
                    <a:ext uri="{9D8B030D-6E8A-4147-A177-3AD203B41FA5}">
                      <a16:colId xmlns:a16="http://schemas.microsoft.com/office/drawing/2014/main" val="3983865921"/>
                    </a:ext>
                  </a:extLst>
                </a:gridCol>
                <a:gridCol w="478949">
                  <a:extLst>
                    <a:ext uri="{9D8B030D-6E8A-4147-A177-3AD203B41FA5}">
                      <a16:colId xmlns:a16="http://schemas.microsoft.com/office/drawing/2014/main" val="1795591093"/>
                    </a:ext>
                  </a:extLst>
                </a:gridCol>
                <a:gridCol w="478949">
                  <a:extLst>
                    <a:ext uri="{9D8B030D-6E8A-4147-A177-3AD203B41FA5}">
                      <a16:colId xmlns:a16="http://schemas.microsoft.com/office/drawing/2014/main" val="1954249163"/>
                    </a:ext>
                  </a:extLst>
                </a:gridCol>
                <a:gridCol w="478949">
                  <a:extLst>
                    <a:ext uri="{9D8B030D-6E8A-4147-A177-3AD203B41FA5}">
                      <a16:colId xmlns:a16="http://schemas.microsoft.com/office/drawing/2014/main" val="2728665830"/>
                    </a:ext>
                  </a:extLst>
                </a:gridCol>
                <a:gridCol w="478949">
                  <a:extLst>
                    <a:ext uri="{9D8B030D-6E8A-4147-A177-3AD203B41FA5}">
                      <a16:colId xmlns:a16="http://schemas.microsoft.com/office/drawing/2014/main" val="784553315"/>
                    </a:ext>
                  </a:extLst>
                </a:gridCol>
                <a:gridCol w="478949">
                  <a:extLst>
                    <a:ext uri="{9D8B030D-6E8A-4147-A177-3AD203B41FA5}">
                      <a16:colId xmlns:a16="http://schemas.microsoft.com/office/drawing/2014/main" val="2047624046"/>
                    </a:ext>
                  </a:extLst>
                </a:gridCol>
                <a:gridCol w="478949">
                  <a:extLst>
                    <a:ext uri="{9D8B030D-6E8A-4147-A177-3AD203B41FA5}">
                      <a16:colId xmlns:a16="http://schemas.microsoft.com/office/drawing/2014/main" val="605411223"/>
                    </a:ext>
                  </a:extLst>
                </a:gridCol>
              </a:tblGrid>
              <a:tr h="329814">
                <a:tc>
                  <a:txBody>
                    <a:bodyPr/>
                    <a:lstStyle/>
                    <a:p>
                      <a:r>
                        <a:rPr lang="en-US" dirty="0" err="1" smtClean="0"/>
                        <a:t>Coc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01335292"/>
                  </a:ext>
                </a:extLst>
              </a:tr>
              <a:tr h="329814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75896317"/>
                  </a:ext>
                </a:extLst>
              </a:tr>
              <a:tr h="329814"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74285937"/>
                  </a:ext>
                </a:extLst>
              </a:tr>
              <a:tr h="329814"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24338767"/>
                  </a:ext>
                </a:extLst>
              </a:tr>
              <a:tr h="329814"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3826811"/>
                  </a:ext>
                </a:extLst>
              </a:tr>
              <a:tr h="329814"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283552"/>
                  </a:ext>
                </a:extLst>
              </a:tr>
              <a:tr h="329814"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09883791"/>
                  </a:ext>
                </a:extLst>
              </a:tr>
              <a:tr h="329814"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68017820"/>
                  </a:ext>
                </a:extLst>
              </a:tr>
              <a:tr h="329814"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9140688"/>
                  </a:ext>
                </a:extLst>
              </a:tr>
              <a:tr h="329814"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2617597"/>
                  </a:ext>
                </a:extLst>
              </a:tr>
              <a:tr h="329814"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117</a:t>
                      </a:r>
                    </a:p>
                  </a:txBody>
                  <a:tcPr marL="9525" marR="9525" marT="9525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9299572"/>
                  </a:ext>
                </a:extLst>
              </a:tr>
              <a:tr h="329814"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54656930"/>
                  </a:ext>
                </a:extLst>
              </a:tr>
              <a:tr h="329814"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23200888"/>
                  </a:ext>
                </a:extLst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18045" y="58642"/>
            <a:ext cx="36876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3 </a:t>
            </a:r>
            <a:r>
              <a:rPr lang="en-US" dirty="0" smtClean="0"/>
              <a:t>Neuron mean amplitudes KW test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634664" y="764061"/>
            <a:ext cx="2045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W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0" y="1359569"/>
            <a:ext cx="11670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smooth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-21056" y="2573528"/>
            <a:ext cx="120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minimal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18046" y="3838879"/>
            <a:ext cx="12332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initial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2430378" y="4729672"/>
            <a:ext cx="12753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smooth</a:t>
            </a:r>
            <a:endParaRPr 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4018548" y="4729672"/>
            <a:ext cx="1660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minimal</a:t>
            </a:r>
            <a:endParaRPr 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5955632" y="4729672"/>
            <a:ext cx="12272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initial</a:t>
            </a:r>
            <a:endParaRPr lang="en-US" dirty="0"/>
          </a:p>
        </p:txBody>
      </p:sp>
      <p:sp>
        <p:nvSpPr>
          <p:cNvPr id="16" name="Left Brace 15"/>
          <p:cNvSpPr/>
          <p:nvPr/>
        </p:nvSpPr>
        <p:spPr>
          <a:xfrm>
            <a:off x="1205563" y="1151385"/>
            <a:ext cx="45719" cy="857889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Left Brace 16"/>
          <p:cNvSpPr/>
          <p:nvPr/>
        </p:nvSpPr>
        <p:spPr>
          <a:xfrm>
            <a:off x="1190224" y="2362748"/>
            <a:ext cx="45719" cy="857889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Left Brace 17"/>
          <p:cNvSpPr/>
          <p:nvPr/>
        </p:nvSpPr>
        <p:spPr>
          <a:xfrm>
            <a:off x="1182703" y="3594600"/>
            <a:ext cx="45719" cy="857889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Left Brace 18"/>
          <p:cNvSpPr/>
          <p:nvPr/>
        </p:nvSpPr>
        <p:spPr>
          <a:xfrm>
            <a:off x="1118335" y="830123"/>
            <a:ext cx="128735" cy="237208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TextBox 27"/>
          <p:cNvSpPr txBox="1"/>
          <p:nvPr/>
        </p:nvSpPr>
        <p:spPr>
          <a:xfrm>
            <a:off x="654712" y="5500505"/>
            <a:ext cx="2045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W</a:t>
            </a:r>
            <a:endParaRPr lang="en-US" dirty="0"/>
          </a:p>
        </p:txBody>
      </p:sp>
      <p:sp>
        <p:nvSpPr>
          <p:cNvPr id="29" name="TextBox 28"/>
          <p:cNvSpPr txBox="1"/>
          <p:nvPr/>
        </p:nvSpPr>
        <p:spPr>
          <a:xfrm>
            <a:off x="20048" y="6096013"/>
            <a:ext cx="11670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smooth</a:t>
            </a:r>
            <a:endParaRPr lang="en-US" dirty="0"/>
          </a:p>
        </p:txBody>
      </p:sp>
      <p:sp>
        <p:nvSpPr>
          <p:cNvPr id="30" name="TextBox 29"/>
          <p:cNvSpPr txBox="1"/>
          <p:nvPr/>
        </p:nvSpPr>
        <p:spPr>
          <a:xfrm>
            <a:off x="-1008" y="7309972"/>
            <a:ext cx="120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minimal</a:t>
            </a:r>
            <a:endParaRPr lang="en-US" dirty="0"/>
          </a:p>
        </p:txBody>
      </p:sp>
      <p:sp>
        <p:nvSpPr>
          <p:cNvPr id="31" name="TextBox 30"/>
          <p:cNvSpPr txBox="1"/>
          <p:nvPr/>
        </p:nvSpPr>
        <p:spPr>
          <a:xfrm>
            <a:off x="38094" y="8575323"/>
            <a:ext cx="12332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initial</a:t>
            </a:r>
            <a:endParaRPr lang="en-US" dirty="0"/>
          </a:p>
        </p:txBody>
      </p:sp>
      <p:sp>
        <p:nvSpPr>
          <p:cNvPr id="32" name="Left Brace 31"/>
          <p:cNvSpPr/>
          <p:nvPr/>
        </p:nvSpPr>
        <p:spPr>
          <a:xfrm>
            <a:off x="1225611" y="5887829"/>
            <a:ext cx="45719" cy="857889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Left Brace 32"/>
          <p:cNvSpPr/>
          <p:nvPr/>
        </p:nvSpPr>
        <p:spPr>
          <a:xfrm>
            <a:off x="1210272" y="7099192"/>
            <a:ext cx="45719" cy="857889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Left Brace 33"/>
          <p:cNvSpPr/>
          <p:nvPr/>
        </p:nvSpPr>
        <p:spPr>
          <a:xfrm>
            <a:off x="1202751" y="8331044"/>
            <a:ext cx="45719" cy="857889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Left Brace 34"/>
          <p:cNvSpPr/>
          <p:nvPr/>
        </p:nvSpPr>
        <p:spPr>
          <a:xfrm>
            <a:off x="1138383" y="5566567"/>
            <a:ext cx="128735" cy="237208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Left Brace 37"/>
          <p:cNvSpPr/>
          <p:nvPr/>
        </p:nvSpPr>
        <p:spPr>
          <a:xfrm rot="16200000">
            <a:off x="1991373" y="4584235"/>
            <a:ext cx="60740" cy="330433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Left Brace 38"/>
          <p:cNvSpPr/>
          <p:nvPr/>
        </p:nvSpPr>
        <p:spPr>
          <a:xfrm rot="5400000">
            <a:off x="1982765" y="4901837"/>
            <a:ext cx="63902" cy="330433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Left Brace 39"/>
          <p:cNvSpPr/>
          <p:nvPr/>
        </p:nvSpPr>
        <p:spPr>
          <a:xfrm rot="16200000">
            <a:off x="2980415" y="4235475"/>
            <a:ext cx="45719" cy="1025474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Left Brace 40"/>
          <p:cNvSpPr/>
          <p:nvPr/>
        </p:nvSpPr>
        <p:spPr>
          <a:xfrm rot="16200000">
            <a:off x="4665702" y="4043339"/>
            <a:ext cx="53230" cy="1419731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Left Brace 41"/>
          <p:cNvSpPr/>
          <p:nvPr/>
        </p:nvSpPr>
        <p:spPr>
          <a:xfrm rot="16200000">
            <a:off x="6546384" y="4143349"/>
            <a:ext cx="45720" cy="1227223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Left Brace 42"/>
          <p:cNvSpPr/>
          <p:nvPr/>
        </p:nvSpPr>
        <p:spPr>
          <a:xfrm rot="5400000">
            <a:off x="2975723" y="4558717"/>
            <a:ext cx="55102" cy="1025475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Left Brace 43"/>
          <p:cNvSpPr/>
          <p:nvPr/>
        </p:nvSpPr>
        <p:spPr>
          <a:xfrm rot="5400000">
            <a:off x="4644160" y="4387148"/>
            <a:ext cx="96314" cy="1419732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Left Brace 44"/>
          <p:cNvSpPr/>
          <p:nvPr/>
        </p:nvSpPr>
        <p:spPr>
          <a:xfrm rot="5400000">
            <a:off x="6562216" y="4478369"/>
            <a:ext cx="50148" cy="1191123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/>
          <p:cNvSpPr txBox="1"/>
          <p:nvPr/>
        </p:nvSpPr>
        <p:spPr>
          <a:xfrm>
            <a:off x="963169" y="9607296"/>
            <a:ext cx="65926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olored boxes indicate significant differences by </a:t>
            </a:r>
            <a:r>
              <a:rPr lang="en-US" dirty="0" err="1" smtClean="0"/>
              <a:t>Kruskal</a:t>
            </a:r>
            <a:r>
              <a:rPr lang="en-US" dirty="0" smtClean="0"/>
              <a:t>-Wallis test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387546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86597911"/>
              </p:ext>
            </p:extLst>
          </p:nvPr>
        </p:nvGraphicFramePr>
        <p:xfrm>
          <a:off x="1285569" y="498647"/>
          <a:ext cx="6352658" cy="421995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88666">
                  <a:extLst>
                    <a:ext uri="{9D8B030D-6E8A-4147-A177-3AD203B41FA5}">
                      <a16:colId xmlns:a16="http://schemas.microsoft.com/office/drawing/2014/main" val="2942199668"/>
                    </a:ext>
                  </a:extLst>
                </a:gridCol>
                <a:gridCol w="488666">
                  <a:extLst>
                    <a:ext uri="{9D8B030D-6E8A-4147-A177-3AD203B41FA5}">
                      <a16:colId xmlns:a16="http://schemas.microsoft.com/office/drawing/2014/main" val="398770999"/>
                    </a:ext>
                  </a:extLst>
                </a:gridCol>
                <a:gridCol w="488666">
                  <a:extLst>
                    <a:ext uri="{9D8B030D-6E8A-4147-A177-3AD203B41FA5}">
                      <a16:colId xmlns:a16="http://schemas.microsoft.com/office/drawing/2014/main" val="2430492878"/>
                    </a:ext>
                  </a:extLst>
                </a:gridCol>
                <a:gridCol w="488666">
                  <a:extLst>
                    <a:ext uri="{9D8B030D-6E8A-4147-A177-3AD203B41FA5}">
                      <a16:colId xmlns:a16="http://schemas.microsoft.com/office/drawing/2014/main" val="2138533568"/>
                    </a:ext>
                  </a:extLst>
                </a:gridCol>
                <a:gridCol w="488666">
                  <a:extLst>
                    <a:ext uri="{9D8B030D-6E8A-4147-A177-3AD203B41FA5}">
                      <a16:colId xmlns:a16="http://schemas.microsoft.com/office/drawing/2014/main" val="2110358798"/>
                    </a:ext>
                  </a:extLst>
                </a:gridCol>
                <a:gridCol w="488666">
                  <a:extLst>
                    <a:ext uri="{9D8B030D-6E8A-4147-A177-3AD203B41FA5}">
                      <a16:colId xmlns:a16="http://schemas.microsoft.com/office/drawing/2014/main" val="3164238819"/>
                    </a:ext>
                  </a:extLst>
                </a:gridCol>
                <a:gridCol w="488666">
                  <a:extLst>
                    <a:ext uri="{9D8B030D-6E8A-4147-A177-3AD203B41FA5}">
                      <a16:colId xmlns:a16="http://schemas.microsoft.com/office/drawing/2014/main" val="3028132598"/>
                    </a:ext>
                  </a:extLst>
                </a:gridCol>
                <a:gridCol w="488666">
                  <a:extLst>
                    <a:ext uri="{9D8B030D-6E8A-4147-A177-3AD203B41FA5}">
                      <a16:colId xmlns:a16="http://schemas.microsoft.com/office/drawing/2014/main" val="3272766504"/>
                    </a:ext>
                  </a:extLst>
                </a:gridCol>
                <a:gridCol w="488666">
                  <a:extLst>
                    <a:ext uri="{9D8B030D-6E8A-4147-A177-3AD203B41FA5}">
                      <a16:colId xmlns:a16="http://schemas.microsoft.com/office/drawing/2014/main" val="1109439154"/>
                    </a:ext>
                  </a:extLst>
                </a:gridCol>
                <a:gridCol w="488666">
                  <a:extLst>
                    <a:ext uri="{9D8B030D-6E8A-4147-A177-3AD203B41FA5}">
                      <a16:colId xmlns:a16="http://schemas.microsoft.com/office/drawing/2014/main" val="741567412"/>
                    </a:ext>
                  </a:extLst>
                </a:gridCol>
                <a:gridCol w="488666">
                  <a:extLst>
                    <a:ext uri="{9D8B030D-6E8A-4147-A177-3AD203B41FA5}">
                      <a16:colId xmlns:a16="http://schemas.microsoft.com/office/drawing/2014/main" val="2791862592"/>
                    </a:ext>
                  </a:extLst>
                </a:gridCol>
                <a:gridCol w="488666">
                  <a:extLst>
                    <a:ext uri="{9D8B030D-6E8A-4147-A177-3AD203B41FA5}">
                      <a16:colId xmlns:a16="http://schemas.microsoft.com/office/drawing/2014/main" val="4121946988"/>
                    </a:ext>
                  </a:extLst>
                </a:gridCol>
                <a:gridCol w="488666">
                  <a:extLst>
                    <a:ext uri="{9D8B030D-6E8A-4147-A177-3AD203B41FA5}">
                      <a16:colId xmlns:a16="http://schemas.microsoft.com/office/drawing/2014/main" val="2941963580"/>
                    </a:ext>
                  </a:extLst>
                </a:gridCol>
              </a:tblGrid>
              <a:tr h="321946">
                <a:tc>
                  <a:txBody>
                    <a:bodyPr/>
                    <a:lstStyle/>
                    <a:p>
                      <a:r>
                        <a:rPr lang="en-US" dirty="0" smtClean="0"/>
                        <a:t>Sal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33335064"/>
                  </a:ext>
                </a:extLst>
              </a:tr>
              <a:tr h="321946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87133239"/>
                  </a:ext>
                </a:extLst>
              </a:tr>
              <a:tr h="321946"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37909565"/>
                  </a:ext>
                </a:extLst>
              </a:tr>
              <a:tr h="321946"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411</a:t>
                      </a:r>
                    </a:p>
                  </a:txBody>
                  <a:tcPr marL="9525" marR="9525" marT="9525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45207261"/>
                  </a:ext>
                </a:extLst>
              </a:tr>
              <a:tr h="321946"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19185664"/>
                  </a:ext>
                </a:extLst>
              </a:tr>
              <a:tr h="321946"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2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47490614"/>
                  </a:ext>
                </a:extLst>
              </a:tr>
              <a:tr h="321946"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82646634"/>
                  </a:ext>
                </a:extLst>
              </a:tr>
              <a:tr h="321946"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54837305"/>
                  </a:ext>
                </a:extLst>
              </a:tr>
              <a:tr h="321946"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60066296"/>
                  </a:ext>
                </a:extLst>
              </a:tr>
              <a:tr h="321946"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82160528"/>
                  </a:ext>
                </a:extLst>
              </a:tr>
              <a:tr h="321946"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82</a:t>
                      </a: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11449281"/>
                  </a:ext>
                </a:extLst>
              </a:tr>
              <a:tr h="321946"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49978490"/>
                  </a:ext>
                </a:extLst>
              </a:tr>
              <a:tr h="321946"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22699954"/>
                  </a:ext>
                </a:extLst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31777167"/>
              </p:ext>
            </p:extLst>
          </p:nvPr>
        </p:nvGraphicFramePr>
        <p:xfrm>
          <a:off x="1315833" y="5199994"/>
          <a:ext cx="6322394" cy="421995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86338">
                  <a:extLst>
                    <a:ext uri="{9D8B030D-6E8A-4147-A177-3AD203B41FA5}">
                      <a16:colId xmlns:a16="http://schemas.microsoft.com/office/drawing/2014/main" val="7848221"/>
                    </a:ext>
                  </a:extLst>
                </a:gridCol>
                <a:gridCol w="486338">
                  <a:extLst>
                    <a:ext uri="{9D8B030D-6E8A-4147-A177-3AD203B41FA5}">
                      <a16:colId xmlns:a16="http://schemas.microsoft.com/office/drawing/2014/main" val="914882174"/>
                    </a:ext>
                  </a:extLst>
                </a:gridCol>
                <a:gridCol w="486338">
                  <a:extLst>
                    <a:ext uri="{9D8B030D-6E8A-4147-A177-3AD203B41FA5}">
                      <a16:colId xmlns:a16="http://schemas.microsoft.com/office/drawing/2014/main" val="2616438921"/>
                    </a:ext>
                  </a:extLst>
                </a:gridCol>
                <a:gridCol w="486338">
                  <a:extLst>
                    <a:ext uri="{9D8B030D-6E8A-4147-A177-3AD203B41FA5}">
                      <a16:colId xmlns:a16="http://schemas.microsoft.com/office/drawing/2014/main" val="3421855541"/>
                    </a:ext>
                  </a:extLst>
                </a:gridCol>
                <a:gridCol w="486338">
                  <a:extLst>
                    <a:ext uri="{9D8B030D-6E8A-4147-A177-3AD203B41FA5}">
                      <a16:colId xmlns:a16="http://schemas.microsoft.com/office/drawing/2014/main" val="4101009158"/>
                    </a:ext>
                  </a:extLst>
                </a:gridCol>
                <a:gridCol w="486338">
                  <a:extLst>
                    <a:ext uri="{9D8B030D-6E8A-4147-A177-3AD203B41FA5}">
                      <a16:colId xmlns:a16="http://schemas.microsoft.com/office/drawing/2014/main" val="1668181931"/>
                    </a:ext>
                  </a:extLst>
                </a:gridCol>
                <a:gridCol w="486338">
                  <a:extLst>
                    <a:ext uri="{9D8B030D-6E8A-4147-A177-3AD203B41FA5}">
                      <a16:colId xmlns:a16="http://schemas.microsoft.com/office/drawing/2014/main" val="2552487791"/>
                    </a:ext>
                  </a:extLst>
                </a:gridCol>
                <a:gridCol w="486338">
                  <a:extLst>
                    <a:ext uri="{9D8B030D-6E8A-4147-A177-3AD203B41FA5}">
                      <a16:colId xmlns:a16="http://schemas.microsoft.com/office/drawing/2014/main" val="2002729812"/>
                    </a:ext>
                  </a:extLst>
                </a:gridCol>
                <a:gridCol w="486338">
                  <a:extLst>
                    <a:ext uri="{9D8B030D-6E8A-4147-A177-3AD203B41FA5}">
                      <a16:colId xmlns:a16="http://schemas.microsoft.com/office/drawing/2014/main" val="2776352982"/>
                    </a:ext>
                  </a:extLst>
                </a:gridCol>
                <a:gridCol w="486338">
                  <a:extLst>
                    <a:ext uri="{9D8B030D-6E8A-4147-A177-3AD203B41FA5}">
                      <a16:colId xmlns:a16="http://schemas.microsoft.com/office/drawing/2014/main" val="3544324336"/>
                    </a:ext>
                  </a:extLst>
                </a:gridCol>
                <a:gridCol w="486338">
                  <a:extLst>
                    <a:ext uri="{9D8B030D-6E8A-4147-A177-3AD203B41FA5}">
                      <a16:colId xmlns:a16="http://schemas.microsoft.com/office/drawing/2014/main" val="3098925749"/>
                    </a:ext>
                  </a:extLst>
                </a:gridCol>
                <a:gridCol w="486338">
                  <a:extLst>
                    <a:ext uri="{9D8B030D-6E8A-4147-A177-3AD203B41FA5}">
                      <a16:colId xmlns:a16="http://schemas.microsoft.com/office/drawing/2014/main" val="3489527232"/>
                    </a:ext>
                  </a:extLst>
                </a:gridCol>
                <a:gridCol w="486338">
                  <a:extLst>
                    <a:ext uri="{9D8B030D-6E8A-4147-A177-3AD203B41FA5}">
                      <a16:colId xmlns:a16="http://schemas.microsoft.com/office/drawing/2014/main" val="768663684"/>
                    </a:ext>
                  </a:extLst>
                </a:gridCol>
              </a:tblGrid>
              <a:tr h="312410">
                <a:tc>
                  <a:txBody>
                    <a:bodyPr/>
                    <a:lstStyle/>
                    <a:p>
                      <a:r>
                        <a:rPr lang="en-US" dirty="0" err="1" smtClean="0"/>
                        <a:t>Coc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56734237"/>
                  </a:ext>
                </a:extLst>
              </a:tr>
              <a:tr h="31241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97226180"/>
                  </a:ext>
                </a:extLst>
              </a:tr>
              <a:tr h="312410"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99677204"/>
                  </a:ext>
                </a:extLst>
              </a:tr>
              <a:tr h="312410"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76098806"/>
                  </a:ext>
                </a:extLst>
              </a:tr>
              <a:tr h="312410"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86596103"/>
                  </a:ext>
                </a:extLst>
              </a:tr>
              <a:tr h="312410"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31434572"/>
                  </a:ext>
                </a:extLst>
              </a:tr>
              <a:tr h="312410"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26561825"/>
                  </a:ext>
                </a:extLst>
              </a:tr>
              <a:tr h="312410"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95284068"/>
                  </a:ext>
                </a:extLst>
              </a:tr>
              <a:tr h="312410"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29392809"/>
                  </a:ext>
                </a:extLst>
              </a:tr>
              <a:tr h="312410"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60804177"/>
                  </a:ext>
                </a:extLst>
              </a:tr>
              <a:tr h="312410"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467</a:t>
                      </a:r>
                    </a:p>
                  </a:txBody>
                  <a:tcPr marL="9525" marR="9525" marT="9525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39695883"/>
                  </a:ext>
                </a:extLst>
              </a:tr>
              <a:tr h="312410"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2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4</a:t>
                      </a: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96939754"/>
                  </a:ext>
                </a:extLst>
              </a:tr>
              <a:tr h="312410"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85301013"/>
                  </a:ext>
                </a:extLst>
              </a:tr>
            </a:tbl>
          </a:graphicData>
        </a:graphic>
      </p:graphicFrame>
      <p:sp>
        <p:nvSpPr>
          <p:cNvPr id="15" name="TextBox 14"/>
          <p:cNvSpPr txBox="1"/>
          <p:nvPr/>
        </p:nvSpPr>
        <p:spPr>
          <a:xfrm>
            <a:off x="18045" y="58642"/>
            <a:ext cx="36876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4 </a:t>
            </a:r>
            <a:r>
              <a:rPr lang="en-US" dirty="0" smtClean="0"/>
              <a:t>Neuron mean frequencies KW test</a:t>
            </a:r>
            <a:endParaRPr 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634664" y="764061"/>
            <a:ext cx="2045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W</a:t>
            </a:r>
            <a:endParaRPr 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0" y="1359569"/>
            <a:ext cx="11670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smooth</a:t>
            </a:r>
            <a:endParaRPr lang="en-US" dirty="0"/>
          </a:p>
        </p:txBody>
      </p:sp>
      <p:sp>
        <p:nvSpPr>
          <p:cNvPr id="18" name="TextBox 17"/>
          <p:cNvSpPr txBox="1"/>
          <p:nvPr/>
        </p:nvSpPr>
        <p:spPr>
          <a:xfrm>
            <a:off x="-21056" y="2573528"/>
            <a:ext cx="120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minimal</a:t>
            </a:r>
            <a:endParaRPr lang="en-US" dirty="0"/>
          </a:p>
        </p:txBody>
      </p:sp>
      <p:sp>
        <p:nvSpPr>
          <p:cNvPr id="19" name="TextBox 18"/>
          <p:cNvSpPr txBox="1"/>
          <p:nvPr/>
        </p:nvSpPr>
        <p:spPr>
          <a:xfrm>
            <a:off x="18046" y="3838879"/>
            <a:ext cx="12332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initial</a:t>
            </a:r>
            <a:endParaRPr lang="en-US" dirty="0"/>
          </a:p>
        </p:txBody>
      </p:sp>
      <p:sp>
        <p:nvSpPr>
          <p:cNvPr id="20" name="Left Brace 19"/>
          <p:cNvSpPr/>
          <p:nvPr/>
        </p:nvSpPr>
        <p:spPr>
          <a:xfrm>
            <a:off x="1205563" y="1151385"/>
            <a:ext cx="45719" cy="857889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Left Brace 20"/>
          <p:cNvSpPr/>
          <p:nvPr/>
        </p:nvSpPr>
        <p:spPr>
          <a:xfrm>
            <a:off x="1190224" y="2362748"/>
            <a:ext cx="45719" cy="857889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Left Brace 21"/>
          <p:cNvSpPr/>
          <p:nvPr/>
        </p:nvSpPr>
        <p:spPr>
          <a:xfrm>
            <a:off x="1182703" y="3594600"/>
            <a:ext cx="45719" cy="857889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Left Brace 22"/>
          <p:cNvSpPr/>
          <p:nvPr/>
        </p:nvSpPr>
        <p:spPr>
          <a:xfrm>
            <a:off x="1118335" y="830123"/>
            <a:ext cx="128735" cy="237208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TextBox 23"/>
          <p:cNvSpPr txBox="1"/>
          <p:nvPr/>
        </p:nvSpPr>
        <p:spPr>
          <a:xfrm>
            <a:off x="654712" y="5500505"/>
            <a:ext cx="2045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W</a:t>
            </a:r>
            <a:endParaRPr lang="en-US" dirty="0"/>
          </a:p>
        </p:txBody>
      </p:sp>
      <p:sp>
        <p:nvSpPr>
          <p:cNvPr id="25" name="TextBox 24"/>
          <p:cNvSpPr txBox="1"/>
          <p:nvPr/>
        </p:nvSpPr>
        <p:spPr>
          <a:xfrm>
            <a:off x="20048" y="6096013"/>
            <a:ext cx="11670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smooth</a:t>
            </a:r>
            <a:endParaRPr lang="en-US" dirty="0"/>
          </a:p>
        </p:txBody>
      </p:sp>
      <p:sp>
        <p:nvSpPr>
          <p:cNvPr id="26" name="TextBox 25"/>
          <p:cNvSpPr txBox="1"/>
          <p:nvPr/>
        </p:nvSpPr>
        <p:spPr>
          <a:xfrm>
            <a:off x="-1008" y="7309972"/>
            <a:ext cx="120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minimal</a:t>
            </a:r>
            <a:endParaRPr lang="en-US" dirty="0"/>
          </a:p>
        </p:txBody>
      </p:sp>
      <p:sp>
        <p:nvSpPr>
          <p:cNvPr id="27" name="TextBox 26"/>
          <p:cNvSpPr txBox="1"/>
          <p:nvPr/>
        </p:nvSpPr>
        <p:spPr>
          <a:xfrm>
            <a:off x="38094" y="8575323"/>
            <a:ext cx="12332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initial</a:t>
            </a:r>
            <a:endParaRPr lang="en-US" dirty="0"/>
          </a:p>
        </p:txBody>
      </p:sp>
      <p:sp>
        <p:nvSpPr>
          <p:cNvPr id="28" name="Left Brace 27"/>
          <p:cNvSpPr/>
          <p:nvPr/>
        </p:nvSpPr>
        <p:spPr>
          <a:xfrm>
            <a:off x="1225611" y="5887829"/>
            <a:ext cx="45719" cy="857889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Left Brace 28"/>
          <p:cNvSpPr/>
          <p:nvPr/>
        </p:nvSpPr>
        <p:spPr>
          <a:xfrm>
            <a:off x="1210272" y="7099192"/>
            <a:ext cx="45719" cy="857889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Left Brace 29"/>
          <p:cNvSpPr/>
          <p:nvPr/>
        </p:nvSpPr>
        <p:spPr>
          <a:xfrm>
            <a:off x="1202751" y="8331044"/>
            <a:ext cx="45719" cy="857889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Left Brace 30"/>
          <p:cNvSpPr/>
          <p:nvPr/>
        </p:nvSpPr>
        <p:spPr>
          <a:xfrm>
            <a:off x="1138383" y="5566567"/>
            <a:ext cx="128735" cy="237208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TextBox 42"/>
          <p:cNvSpPr txBox="1"/>
          <p:nvPr/>
        </p:nvSpPr>
        <p:spPr>
          <a:xfrm>
            <a:off x="1820964" y="4772204"/>
            <a:ext cx="3609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W</a:t>
            </a:r>
            <a:endParaRPr lang="en-US" dirty="0"/>
          </a:p>
        </p:txBody>
      </p:sp>
      <p:sp>
        <p:nvSpPr>
          <p:cNvPr id="44" name="TextBox 43"/>
          <p:cNvSpPr txBox="1"/>
          <p:nvPr/>
        </p:nvSpPr>
        <p:spPr>
          <a:xfrm>
            <a:off x="2430378" y="4772204"/>
            <a:ext cx="12753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smooth</a:t>
            </a:r>
            <a:endParaRPr lang="en-US" dirty="0"/>
          </a:p>
        </p:txBody>
      </p:sp>
      <p:sp>
        <p:nvSpPr>
          <p:cNvPr id="45" name="TextBox 44"/>
          <p:cNvSpPr txBox="1"/>
          <p:nvPr/>
        </p:nvSpPr>
        <p:spPr>
          <a:xfrm>
            <a:off x="4018548" y="4772204"/>
            <a:ext cx="1660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minimal</a:t>
            </a:r>
            <a:endParaRPr lang="en-US" dirty="0"/>
          </a:p>
        </p:txBody>
      </p:sp>
      <p:sp>
        <p:nvSpPr>
          <p:cNvPr id="46" name="TextBox 45"/>
          <p:cNvSpPr txBox="1"/>
          <p:nvPr/>
        </p:nvSpPr>
        <p:spPr>
          <a:xfrm>
            <a:off x="5955632" y="4772204"/>
            <a:ext cx="12272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initial</a:t>
            </a:r>
            <a:endParaRPr lang="en-US" dirty="0"/>
          </a:p>
        </p:txBody>
      </p:sp>
      <p:sp>
        <p:nvSpPr>
          <p:cNvPr id="47" name="Left Brace 46"/>
          <p:cNvSpPr/>
          <p:nvPr/>
        </p:nvSpPr>
        <p:spPr>
          <a:xfrm rot="16200000">
            <a:off x="1991373" y="4584235"/>
            <a:ext cx="60740" cy="330433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Left Brace 47"/>
          <p:cNvSpPr/>
          <p:nvPr/>
        </p:nvSpPr>
        <p:spPr>
          <a:xfrm rot="5400000">
            <a:off x="1982765" y="4944369"/>
            <a:ext cx="63902" cy="330433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Left Brace 48"/>
          <p:cNvSpPr/>
          <p:nvPr/>
        </p:nvSpPr>
        <p:spPr>
          <a:xfrm rot="16200000">
            <a:off x="2980415" y="4278007"/>
            <a:ext cx="45719" cy="1025474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Left Brace 49"/>
          <p:cNvSpPr/>
          <p:nvPr/>
        </p:nvSpPr>
        <p:spPr>
          <a:xfrm rot="16200000">
            <a:off x="4665702" y="4085871"/>
            <a:ext cx="53230" cy="1419731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Left Brace 50"/>
          <p:cNvSpPr/>
          <p:nvPr/>
        </p:nvSpPr>
        <p:spPr>
          <a:xfrm rot="16200000">
            <a:off x="6546384" y="4185881"/>
            <a:ext cx="45720" cy="1227223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Left Brace 51"/>
          <p:cNvSpPr/>
          <p:nvPr/>
        </p:nvSpPr>
        <p:spPr>
          <a:xfrm rot="5400000">
            <a:off x="2975723" y="4601249"/>
            <a:ext cx="55102" cy="1025475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Left Brace 52"/>
          <p:cNvSpPr/>
          <p:nvPr/>
        </p:nvSpPr>
        <p:spPr>
          <a:xfrm rot="5400000">
            <a:off x="4644160" y="4429680"/>
            <a:ext cx="96314" cy="1419732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Left Brace 53"/>
          <p:cNvSpPr/>
          <p:nvPr/>
        </p:nvSpPr>
        <p:spPr>
          <a:xfrm rot="5400000">
            <a:off x="6562216" y="4520901"/>
            <a:ext cx="50148" cy="1191123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TextBox 32"/>
          <p:cNvSpPr txBox="1"/>
          <p:nvPr/>
        </p:nvSpPr>
        <p:spPr>
          <a:xfrm>
            <a:off x="963169" y="9607296"/>
            <a:ext cx="65926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olored boxes indicate significant differences by </a:t>
            </a:r>
            <a:r>
              <a:rPr lang="en-US" dirty="0" err="1" smtClean="0"/>
              <a:t>Kruskal</a:t>
            </a:r>
            <a:r>
              <a:rPr lang="en-US" dirty="0" smtClean="0"/>
              <a:t>-Wallis test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747480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31278503"/>
              </p:ext>
            </p:extLst>
          </p:nvPr>
        </p:nvGraphicFramePr>
        <p:xfrm>
          <a:off x="1305622" y="427974"/>
          <a:ext cx="6309823" cy="428617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85371">
                  <a:extLst>
                    <a:ext uri="{9D8B030D-6E8A-4147-A177-3AD203B41FA5}">
                      <a16:colId xmlns:a16="http://schemas.microsoft.com/office/drawing/2014/main" val="451738927"/>
                    </a:ext>
                  </a:extLst>
                </a:gridCol>
                <a:gridCol w="485371">
                  <a:extLst>
                    <a:ext uri="{9D8B030D-6E8A-4147-A177-3AD203B41FA5}">
                      <a16:colId xmlns:a16="http://schemas.microsoft.com/office/drawing/2014/main" val="225230524"/>
                    </a:ext>
                  </a:extLst>
                </a:gridCol>
                <a:gridCol w="485371">
                  <a:extLst>
                    <a:ext uri="{9D8B030D-6E8A-4147-A177-3AD203B41FA5}">
                      <a16:colId xmlns:a16="http://schemas.microsoft.com/office/drawing/2014/main" val="2601610991"/>
                    </a:ext>
                  </a:extLst>
                </a:gridCol>
                <a:gridCol w="485371">
                  <a:extLst>
                    <a:ext uri="{9D8B030D-6E8A-4147-A177-3AD203B41FA5}">
                      <a16:colId xmlns:a16="http://schemas.microsoft.com/office/drawing/2014/main" val="666090352"/>
                    </a:ext>
                  </a:extLst>
                </a:gridCol>
                <a:gridCol w="485371">
                  <a:extLst>
                    <a:ext uri="{9D8B030D-6E8A-4147-A177-3AD203B41FA5}">
                      <a16:colId xmlns:a16="http://schemas.microsoft.com/office/drawing/2014/main" val="1135607957"/>
                    </a:ext>
                  </a:extLst>
                </a:gridCol>
                <a:gridCol w="485371">
                  <a:extLst>
                    <a:ext uri="{9D8B030D-6E8A-4147-A177-3AD203B41FA5}">
                      <a16:colId xmlns:a16="http://schemas.microsoft.com/office/drawing/2014/main" val="293683554"/>
                    </a:ext>
                  </a:extLst>
                </a:gridCol>
                <a:gridCol w="485371">
                  <a:extLst>
                    <a:ext uri="{9D8B030D-6E8A-4147-A177-3AD203B41FA5}">
                      <a16:colId xmlns:a16="http://schemas.microsoft.com/office/drawing/2014/main" val="1471626475"/>
                    </a:ext>
                  </a:extLst>
                </a:gridCol>
                <a:gridCol w="485371">
                  <a:extLst>
                    <a:ext uri="{9D8B030D-6E8A-4147-A177-3AD203B41FA5}">
                      <a16:colId xmlns:a16="http://schemas.microsoft.com/office/drawing/2014/main" val="729491155"/>
                    </a:ext>
                  </a:extLst>
                </a:gridCol>
                <a:gridCol w="485371">
                  <a:extLst>
                    <a:ext uri="{9D8B030D-6E8A-4147-A177-3AD203B41FA5}">
                      <a16:colId xmlns:a16="http://schemas.microsoft.com/office/drawing/2014/main" val="1120439790"/>
                    </a:ext>
                  </a:extLst>
                </a:gridCol>
                <a:gridCol w="485371">
                  <a:extLst>
                    <a:ext uri="{9D8B030D-6E8A-4147-A177-3AD203B41FA5}">
                      <a16:colId xmlns:a16="http://schemas.microsoft.com/office/drawing/2014/main" val="1559613644"/>
                    </a:ext>
                  </a:extLst>
                </a:gridCol>
                <a:gridCol w="485371">
                  <a:extLst>
                    <a:ext uri="{9D8B030D-6E8A-4147-A177-3AD203B41FA5}">
                      <a16:colId xmlns:a16="http://schemas.microsoft.com/office/drawing/2014/main" val="1445904154"/>
                    </a:ext>
                  </a:extLst>
                </a:gridCol>
                <a:gridCol w="485371">
                  <a:extLst>
                    <a:ext uri="{9D8B030D-6E8A-4147-A177-3AD203B41FA5}">
                      <a16:colId xmlns:a16="http://schemas.microsoft.com/office/drawing/2014/main" val="796825215"/>
                    </a:ext>
                  </a:extLst>
                </a:gridCol>
                <a:gridCol w="485371">
                  <a:extLst>
                    <a:ext uri="{9D8B030D-6E8A-4147-A177-3AD203B41FA5}">
                      <a16:colId xmlns:a16="http://schemas.microsoft.com/office/drawing/2014/main" val="425412108"/>
                    </a:ext>
                  </a:extLst>
                </a:gridCol>
              </a:tblGrid>
              <a:tr h="329706">
                <a:tc>
                  <a:txBody>
                    <a:bodyPr/>
                    <a:lstStyle/>
                    <a:p>
                      <a:r>
                        <a:rPr lang="en-US" dirty="0" smtClean="0"/>
                        <a:t>Sal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17613776"/>
                  </a:ext>
                </a:extLst>
              </a:tr>
              <a:tr h="329706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20698438"/>
                  </a:ext>
                </a:extLst>
              </a:tr>
              <a:tr h="329706"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47198635"/>
                  </a:ext>
                </a:extLst>
              </a:tr>
              <a:tr h="329706"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4650175"/>
                  </a:ext>
                </a:extLst>
              </a:tr>
              <a:tr h="329706"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31903061"/>
                  </a:ext>
                </a:extLst>
              </a:tr>
              <a:tr h="329706"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47078926"/>
                  </a:ext>
                </a:extLst>
              </a:tr>
              <a:tr h="329706"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1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47597170"/>
                  </a:ext>
                </a:extLst>
              </a:tr>
              <a:tr h="329706"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17</a:t>
                      </a: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0924627"/>
                  </a:ext>
                </a:extLst>
              </a:tr>
              <a:tr h="329706"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76213968"/>
                  </a:ext>
                </a:extLst>
              </a:tr>
              <a:tr h="329706"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08973708"/>
                  </a:ext>
                </a:extLst>
              </a:tr>
              <a:tr h="329706"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98597735"/>
                  </a:ext>
                </a:extLst>
              </a:tr>
              <a:tr h="329706"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59589158"/>
                  </a:ext>
                </a:extLst>
              </a:tr>
              <a:tr h="329706"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79675231"/>
                  </a:ext>
                </a:extLst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8944553"/>
              </p:ext>
            </p:extLst>
          </p:nvPr>
        </p:nvGraphicFramePr>
        <p:xfrm>
          <a:off x="1305622" y="5186154"/>
          <a:ext cx="6309823" cy="429473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85371">
                  <a:extLst>
                    <a:ext uri="{9D8B030D-6E8A-4147-A177-3AD203B41FA5}">
                      <a16:colId xmlns:a16="http://schemas.microsoft.com/office/drawing/2014/main" val="3111626955"/>
                    </a:ext>
                  </a:extLst>
                </a:gridCol>
                <a:gridCol w="485371">
                  <a:extLst>
                    <a:ext uri="{9D8B030D-6E8A-4147-A177-3AD203B41FA5}">
                      <a16:colId xmlns:a16="http://schemas.microsoft.com/office/drawing/2014/main" val="1938832494"/>
                    </a:ext>
                  </a:extLst>
                </a:gridCol>
                <a:gridCol w="485371">
                  <a:extLst>
                    <a:ext uri="{9D8B030D-6E8A-4147-A177-3AD203B41FA5}">
                      <a16:colId xmlns:a16="http://schemas.microsoft.com/office/drawing/2014/main" val="1347719349"/>
                    </a:ext>
                  </a:extLst>
                </a:gridCol>
                <a:gridCol w="485371">
                  <a:extLst>
                    <a:ext uri="{9D8B030D-6E8A-4147-A177-3AD203B41FA5}">
                      <a16:colId xmlns:a16="http://schemas.microsoft.com/office/drawing/2014/main" val="1714258020"/>
                    </a:ext>
                  </a:extLst>
                </a:gridCol>
                <a:gridCol w="485371">
                  <a:extLst>
                    <a:ext uri="{9D8B030D-6E8A-4147-A177-3AD203B41FA5}">
                      <a16:colId xmlns:a16="http://schemas.microsoft.com/office/drawing/2014/main" val="3253936898"/>
                    </a:ext>
                  </a:extLst>
                </a:gridCol>
                <a:gridCol w="485371">
                  <a:extLst>
                    <a:ext uri="{9D8B030D-6E8A-4147-A177-3AD203B41FA5}">
                      <a16:colId xmlns:a16="http://schemas.microsoft.com/office/drawing/2014/main" val="3626344134"/>
                    </a:ext>
                  </a:extLst>
                </a:gridCol>
                <a:gridCol w="485371">
                  <a:extLst>
                    <a:ext uri="{9D8B030D-6E8A-4147-A177-3AD203B41FA5}">
                      <a16:colId xmlns:a16="http://schemas.microsoft.com/office/drawing/2014/main" val="2967495614"/>
                    </a:ext>
                  </a:extLst>
                </a:gridCol>
                <a:gridCol w="485371">
                  <a:extLst>
                    <a:ext uri="{9D8B030D-6E8A-4147-A177-3AD203B41FA5}">
                      <a16:colId xmlns:a16="http://schemas.microsoft.com/office/drawing/2014/main" val="1944965825"/>
                    </a:ext>
                  </a:extLst>
                </a:gridCol>
                <a:gridCol w="485371">
                  <a:extLst>
                    <a:ext uri="{9D8B030D-6E8A-4147-A177-3AD203B41FA5}">
                      <a16:colId xmlns:a16="http://schemas.microsoft.com/office/drawing/2014/main" val="1995123067"/>
                    </a:ext>
                  </a:extLst>
                </a:gridCol>
                <a:gridCol w="485371">
                  <a:extLst>
                    <a:ext uri="{9D8B030D-6E8A-4147-A177-3AD203B41FA5}">
                      <a16:colId xmlns:a16="http://schemas.microsoft.com/office/drawing/2014/main" val="1175357508"/>
                    </a:ext>
                  </a:extLst>
                </a:gridCol>
                <a:gridCol w="485371">
                  <a:extLst>
                    <a:ext uri="{9D8B030D-6E8A-4147-A177-3AD203B41FA5}">
                      <a16:colId xmlns:a16="http://schemas.microsoft.com/office/drawing/2014/main" val="4265304990"/>
                    </a:ext>
                  </a:extLst>
                </a:gridCol>
                <a:gridCol w="485371">
                  <a:extLst>
                    <a:ext uri="{9D8B030D-6E8A-4147-A177-3AD203B41FA5}">
                      <a16:colId xmlns:a16="http://schemas.microsoft.com/office/drawing/2014/main" val="321923720"/>
                    </a:ext>
                  </a:extLst>
                </a:gridCol>
                <a:gridCol w="485371">
                  <a:extLst>
                    <a:ext uri="{9D8B030D-6E8A-4147-A177-3AD203B41FA5}">
                      <a16:colId xmlns:a16="http://schemas.microsoft.com/office/drawing/2014/main" val="764864790"/>
                    </a:ext>
                  </a:extLst>
                </a:gridCol>
              </a:tblGrid>
              <a:tr h="330364">
                <a:tc>
                  <a:txBody>
                    <a:bodyPr/>
                    <a:lstStyle/>
                    <a:p>
                      <a:r>
                        <a:rPr lang="en-US" dirty="0" err="1" smtClean="0"/>
                        <a:t>Coc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04662530"/>
                  </a:ext>
                </a:extLst>
              </a:tr>
              <a:tr h="330364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30480337"/>
                  </a:ext>
                </a:extLst>
              </a:tr>
              <a:tr h="330364"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08859971"/>
                  </a:ext>
                </a:extLst>
              </a:tr>
              <a:tr h="330364"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20093482"/>
                  </a:ext>
                </a:extLst>
              </a:tr>
              <a:tr h="330364"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42854139"/>
                  </a:ext>
                </a:extLst>
              </a:tr>
              <a:tr h="330364"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47357829"/>
                  </a:ext>
                </a:extLst>
              </a:tr>
              <a:tr h="330364"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51010544"/>
                  </a:ext>
                </a:extLst>
              </a:tr>
              <a:tr h="330364"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69627364"/>
                  </a:ext>
                </a:extLst>
              </a:tr>
              <a:tr h="330364"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17143988"/>
                  </a:ext>
                </a:extLst>
              </a:tr>
              <a:tr h="330364"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147</a:t>
                      </a:r>
                    </a:p>
                  </a:txBody>
                  <a:tcPr marL="9525" marR="9525" marT="9525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50142851"/>
                  </a:ext>
                </a:extLst>
              </a:tr>
              <a:tr h="330364"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73982334"/>
                  </a:ext>
                </a:extLst>
              </a:tr>
              <a:tr h="330364"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37413865"/>
                  </a:ext>
                </a:extLst>
              </a:tr>
              <a:tr h="330364"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19147753"/>
                  </a:ext>
                </a:extLst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18046" y="58642"/>
            <a:ext cx="3471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5 </a:t>
            </a:r>
            <a:r>
              <a:rPr lang="en-US" dirty="0" smtClean="0"/>
              <a:t>Neuron mean durations KW test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634664" y="764061"/>
            <a:ext cx="2045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W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0" y="1359569"/>
            <a:ext cx="11670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smooth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-21056" y="2573528"/>
            <a:ext cx="120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minimal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18046" y="3838879"/>
            <a:ext cx="12332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initial</a:t>
            </a:r>
            <a:endParaRPr lang="en-US" dirty="0"/>
          </a:p>
        </p:txBody>
      </p:sp>
      <p:sp>
        <p:nvSpPr>
          <p:cNvPr id="12" name="Left Brace 11"/>
          <p:cNvSpPr/>
          <p:nvPr/>
        </p:nvSpPr>
        <p:spPr>
          <a:xfrm>
            <a:off x="1205563" y="1151385"/>
            <a:ext cx="45719" cy="857889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Left Brace 12"/>
          <p:cNvSpPr/>
          <p:nvPr/>
        </p:nvSpPr>
        <p:spPr>
          <a:xfrm>
            <a:off x="1190224" y="2362748"/>
            <a:ext cx="45719" cy="857889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Left Brace 13"/>
          <p:cNvSpPr/>
          <p:nvPr/>
        </p:nvSpPr>
        <p:spPr>
          <a:xfrm>
            <a:off x="1182703" y="3594600"/>
            <a:ext cx="45719" cy="857889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Left Brace 14"/>
          <p:cNvSpPr/>
          <p:nvPr/>
        </p:nvSpPr>
        <p:spPr>
          <a:xfrm>
            <a:off x="1118335" y="830123"/>
            <a:ext cx="128735" cy="237208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extBox 15"/>
          <p:cNvSpPr txBox="1"/>
          <p:nvPr/>
        </p:nvSpPr>
        <p:spPr>
          <a:xfrm>
            <a:off x="654712" y="5500505"/>
            <a:ext cx="2045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W</a:t>
            </a:r>
            <a:endParaRPr 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20048" y="6096013"/>
            <a:ext cx="11670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smooth</a:t>
            </a:r>
            <a:endParaRPr lang="en-US" dirty="0"/>
          </a:p>
        </p:txBody>
      </p:sp>
      <p:sp>
        <p:nvSpPr>
          <p:cNvPr id="18" name="TextBox 17"/>
          <p:cNvSpPr txBox="1"/>
          <p:nvPr/>
        </p:nvSpPr>
        <p:spPr>
          <a:xfrm>
            <a:off x="-1008" y="7309972"/>
            <a:ext cx="120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minimal</a:t>
            </a:r>
            <a:endParaRPr lang="en-US" dirty="0"/>
          </a:p>
        </p:txBody>
      </p:sp>
      <p:sp>
        <p:nvSpPr>
          <p:cNvPr id="19" name="TextBox 18"/>
          <p:cNvSpPr txBox="1"/>
          <p:nvPr/>
        </p:nvSpPr>
        <p:spPr>
          <a:xfrm>
            <a:off x="38094" y="8575323"/>
            <a:ext cx="12332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initial</a:t>
            </a:r>
            <a:endParaRPr lang="en-US" dirty="0"/>
          </a:p>
        </p:txBody>
      </p:sp>
      <p:sp>
        <p:nvSpPr>
          <p:cNvPr id="20" name="Left Brace 19"/>
          <p:cNvSpPr/>
          <p:nvPr/>
        </p:nvSpPr>
        <p:spPr>
          <a:xfrm>
            <a:off x="1225611" y="5887829"/>
            <a:ext cx="45719" cy="857889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Left Brace 20"/>
          <p:cNvSpPr/>
          <p:nvPr/>
        </p:nvSpPr>
        <p:spPr>
          <a:xfrm>
            <a:off x="1210272" y="7099192"/>
            <a:ext cx="45719" cy="857889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Left Brace 21"/>
          <p:cNvSpPr/>
          <p:nvPr/>
        </p:nvSpPr>
        <p:spPr>
          <a:xfrm>
            <a:off x="1202751" y="8331044"/>
            <a:ext cx="45719" cy="857889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Left Brace 22"/>
          <p:cNvSpPr/>
          <p:nvPr/>
        </p:nvSpPr>
        <p:spPr>
          <a:xfrm>
            <a:off x="1138383" y="5566567"/>
            <a:ext cx="128735" cy="237208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TextBox 34"/>
          <p:cNvSpPr txBox="1"/>
          <p:nvPr/>
        </p:nvSpPr>
        <p:spPr>
          <a:xfrm>
            <a:off x="1820964" y="4772204"/>
            <a:ext cx="3609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W</a:t>
            </a:r>
            <a:endParaRPr lang="en-US" dirty="0"/>
          </a:p>
        </p:txBody>
      </p:sp>
      <p:sp>
        <p:nvSpPr>
          <p:cNvPr id="36" name="TextBox 35"/>
          <p:cNvSpPr txBox="1"/>
          <p:nvPr/>
        </p:nvSpPr>
        <p:spPr>
          <a:xfrm>
            <a:off x="2430378" y="4772204"/>
            <a:ext cx="12753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smooth</a:t>
            </a:r>
            <a:endParaRPr lang="en-US" dirty="0"/>
          </a:p>
        </p:txBody>
      </p:sp>
      <p:sp>
        <p:nvSpPr>
          <p:cNvPr id="37" name="TextBox 36"/>
          <p:cNvSpPr txBox="1"/>
          <p:nvPr/>
        </p:nvSpPr>
        <p:spPr>
          <a:xfrm>
            <a:off x="4018548" y="4772204"/>
            <a:ext cx="1660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minimal</a:t>
            </a:r>
            <a:endParaRPr lang="en-US" dirty="0"/>
          </a:p>
        </p:txBody>
      </p:sp>
      <p:sp>
        <p:nvSpPr>
          <p:cNvPr id="38" name="TextBox 37"/>
          <p:cNvSpPr txBox="1"/>
          <p:nvPr/>
        </p:nvSpPr>
        <p:spPr>
          <a:xfrm>
            <a:off x="5955632" y="4772204"/>
            <a:ext cx="12272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initial</a:t>
            </a:r>
            <a:endParaRPr lang="en-US" dirty="0"/>
          </a:p>
        </p:txBody>
      </p:sp>
      <p:sp>
        <p:nvSpPr>
          <p:cNvPr id="39" name="Left Brace 38"/>
          <p:cNvSpPr/>
          <p:nvPr/>
        </p:nvSpPr>
        <p:spPr>
          <a:xfrm rot="16200000">
            <a:off x="1991373" y="4584235"/>
            <a:ext cx="60740" cy="330433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Left Brace 39"/>
          <p:cNvSpPr/>
          <p:nvPr/>
        </p:nvSpPr>
        <p:spPr>
          <a:xfrm rot="5400000">
            <a:off x="1982765" y="4944369"/>
            <a:ext cx="63902" cy="330433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Left Brace 40"/>
          <p:cNvSpPr/>
          <p:nvPr/>
        </p:nvSpPr>
        <p:spPr>
          <a:xfrm rot="16200000">
            <a:off x="2980415" y="4278007"/>
            <a:ext cx="45719" cy="1025474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Left Brace 41"/>
          <p:cNvSpPr/>
          <p:nvPr/>
        </p:nvSpPr>
        <p:spPr>
          <a:xfrm rot="16200000">
            <a:off x="4665702" y="4085871"/>
            <a:ext cx="53230" cy="1419731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Left Brace 42"/>
          <p:cNvSpPr/>
          <p:nvPr/>
        </p:nvSpPr>
        <p:spPr>
          <a:xfrm rot="16200000">
            <a:off x="6546384" y="4185881"/>
            <a:ext cx="45720" cy="1227223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Left Brace 43"/>
          <p:cNvSpPr/>
          <p:nvPr/>
        </p:nvSpPr>
        <p:spPr>
          <a:xfrm rot="5400000">
            <a:off x="2975723" y="4601249"/>
            <a:ext cx="55102" cy="1025475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Left Brace 44"/>
          <p:cNvSpPr/>
          <p:nvPr/>
        </p:nvSpPr>
        <p:spPr>
          <a:xfrm rot="5400000">
            <a:off x="4644160" y="4429680"/>
            <a:ext cx="96314" cy="1419732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Left Brace 45"/>
          <p:cNvSpPr/>
          <p:nvPr/>
        </p:nvSpPr>
        <p:spPr>
          <a:xfrm rot="5400000">
            <a:off x="6562216" y="4520901"/>
            <a:ext cx="50148" cy="1191123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TextBox 32"/>
          <p:cNvSpPr txBox="1"/>
          <p:nvPr/>
        </p:nvSpPr>
        <p:spPr>
          <a:xfrm>
            <a:off x="963169" y="9607296"/>
            <a:ext cx="65926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olored boxes indicate significant differences by </a:t>
            </a:r>
            <a:r>
              <a:rPr lang="en-US" dirty="0" err="1" smtClean="0"/>
              <a:t>Kruskal</a:t>
            </a:r>
            <a:r>
              <a:rPr lang="en-US" dirty="0" smtClean="0"/>
              <a:t>-Wallis test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074811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56160949"/>
              </p:ext>
            </p:extLst>
          </p:nvPr>
        </p:nvGraphicFramePr>
        <p:xfrm>
          <a:off x="1285570" y="457199"/>
          <a:ext cx="6261632" cy="423900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81664">
                  <a:extLst>
                    <a:ext uri="{9D8B030D-6E8A-4147-A177-3AD203B41FA5}">
                      <a16:colId xmlns:a16="http://schemas.microsoft.com/office/drawing/2014/main" val="4205108466"/>
                    </a:ext>
                  </a:extLst>
                </a:gridCol>
                <a:gridCol w="481664">
                  <a:extLst>
                    <a:ext uri="{9D8B030D-6E8A-4147-A177-3AD203B41FA5}">
                      <a16:colId xmlns:a16="http://schemas.microsoft.com/office/drawing/2014/main" val="1878353026"/>
                    </a:ext>
                  </a:extLst>
                </a:gridCol>
                <a:gridCol w="481664">
                  <a:extLst>
                    <a:ext uri="{9D8B030D-6E8A-4147-A177-3AD203B41FA5}">
                      <a16:colId xmlns:a16="http://schemas.microsoft.com/office/drawing/2014/main" val="3731821567"/>
                    </a:ext>
                  </a:extLst>
                </a:gridCol>
                <a:gridCol w="481664">
                  <a:extLst>
                    <a:ext uri="{9D8B030D-6E8A-4147-A177-3AD203B41FA5}">
                      <a16:colId xmlns:a16="http://schemas.microsoft.com/office/drawing/2014/main" val="2721318606"/>
                    </a:ext>
                  </a:extLst>
                </a:gridCol>
                <a:gridCol w="481664">
                  <a:extLst>
                    <a:ext uri="{9D8B030D-6E8A-4147-A177-3AD203B41FA5}">
                      <a16:colId xmlns:a16="http://schemas.microsoft.com/office/drawing/2014/main" val="3661471882"/>
                    </a:ext>
                  </a:extLst>
                </a:gridCol>
                <a:gridCol w="481664">
                  <a:extLst>
                    <a:ext uri="{9D8B030D-6E8A-4147-A177-3AD203B41FA5}">
                      <a16:colId xmlns:a16="http://schemas.microsoft.com/office/drawing/2014/main" val="3688345384"/>
                    </a:ext>
                  </a:extLst>
                </a:gridCol>
                <a:gridCol w="481664">
                  <a:extLst>
                    <a:ext uri="{9D8B030D-6E8A-4147-A177-3AD203B41FA5}">
                      <a16:colId xmlns:a16="http://schemas.microsoft.com/office/drawing/2014/main" val="4184165124"/>
                    </a:ext>
                  </a:extLst>
                </a:gridCol>
                <a:gridCol w="481664">
                  <a:extLst>
                    <a:ext uri="{9D8B030D-6E8A-4147-A177-3AD203B41FA5}">
                      <a16:colId xmlns:a16="http://schemas.microsoft.com/office/drawing/2014/main" val="3096425814"/>
                    </a:ext>
                  </a:extLst>
                </a:gridCol>
                <a:gridCol w="481664">
                  <a:extLst>
                    <a:ext uri="{9D8B030D-6E8A-4147-A177-3AD203B41FA5}">
                      <a16:colId xmlns:a16="http://schemas.microsoft.com/office/drawing/2014/main" val="3397419283"/>
                    </a:ext>
                  </a:extLst>
                </a:gridCol>
                <a:gridCol w="481664">
                  <a:extLst>
                    <a:ext uri="{9D8B030D-6E8A-4147-A177-3AD203B41FA5}">
                      <a16:colId xmlns:a16="http://schemas.microsoft.com/office/drawing/2014/main" val="2041993592"/>
                    </a:ext>
                  </a:extLst>
                </a:gridCol>
                <a:gridCol w="481664">
                  <a:extLst>
                    <a:ext uri="{9D8B030D-6E8A-4147-A177-3AD203B41FA5}">
                      <a16:colId xmlns:a16="http://schemas.microsoft.com/office/drawing/2014/main" val="377896078"/>
                    </a:ext>
                  </a:extLst>
                </a:gridCol>
                <a:gridCol w="481664">
                  <a:extLst>
                    <a:ext uri="{9D8B030D-6E8A-4147-A177-3AD203B41FA5}">
                      <a16:colId xmlns:a16="http://schemas.microsoft.com/office/drawing/2014/main" val="3674504101"/>
                    </a:ext>
                  </a:extLst>
                </a:gridCol>
                <a:gridCol w="481664">
                  <a:extLst>
                    <a:ext uri="{9D8B030D-6E8A-4147-A177-3AD203B41FA5}">
                      <a16:colId xmlns:a16="http://schemas.microsoft.com/office/drawing/2014/main" val="1946901478"/>
                    </a:ext>
                  </a:extLst>
                </a:gridCol>
              </a:tblGrid>
              <a:tr h="326077">
                <a:tc>
                  <a:txBody>
                    <a:bodyPr/>
                    <a:lstStyle/>
                    <a:p>
                      <a:r>
                        <a:rPr lang="en-US" dirty="0" smtClean="0"/>
                        <a:t>Sal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50499145"/>
                  </a:ext>
                </a:extLst>
              </a:tr>
              <a:tr h="326077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14755554"/>
                  </a:ext>
                </a:extLst>
              </a:tr>
              <a:tr h="326077"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24046044"/>
                  </a:ext>
                </a:extLst>
              </a:tr>
              <a:tr h="326077"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5356198"/>
                  </a:ext>
                </a:extLst>
              </a:tr>
              <a:tr h="326077"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7487379"/>
                  </a:ext>
                </a:extLst>
              </a:tr>
              <a:tr h="326077"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4128871"/>
                  </a:ext>
                </a:extLst>
              </a:tr>
              <a:tr h="326077"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01593134"/>
                  </a:ext>
                </a:extLst>
              </a:tr>
              <a:tr h="326077"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11</a:t>
                      </a: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7645561"/>
                  </a:ext>
                </a:extLst>
              </a:tr>
              <a:tr h="326077"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5816942"/>
                  </a:ext>
                </a:extLst>
              </a:tr>
              <a:tr h="326077"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39645725"/>
                  </a:ext>
                </a:extLst>
              </a:tr>
              <a:tr h="326077"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83516937"/>
                  </a:ext>
                </a:extLst>
              </a:tr>
              <a:tr h="326077"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41858448"/>
                  </a:ext>
                </a:extLst>
              </a:tr>
              <a:tr h="326077"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91</a:t>
                      </a: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34260543"/>
                  </a:ext>
                </a:extLst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88243222"/>
              </p:ext>
            </p:extLst>
          </p:nvPr>
        </p:nvGraphicFramePr>
        <p:xfrm>
          <a:off x="1285576" y="5186281"/>
          <a:ext cx="6261632" cy="424347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81664">
                  <a:extLst>
                    <a:ext uri="{9D8B030D-6E8A-4147-A177-3AD203B41FA5}">
                      <a16:colId xmlns:a16="http://schemas.microsoft.com/office/drawing/2014/main" val="4205108466"/>
                    </a:ext>
                  </a:extLst>
                </a:gridCol>
                <a:gridCol w="481664">
                  <a:extLst>
                    <a:ext uri="{9D8B030D-6E8A-4147-A177-3AD203B41FA5}">
                      <a16:colId xmlns:a16="http://schemas.microsoft.com/office/drawing/2014/main" val="1878353026"/>
                    </a:ext>
                  </a:extLst>
                </a:gridCol>
                <a:gridCol w="481664">
                  <a:extLst>
                    <a:ext uri="{9D8B030D-6E8A-4147-A177-3AD203B41FA5}">
                      <a16:colId xmlns:a16="http://schemas.microsoft.com/office/drawing/2014/main" val="3731821567"/>
                    </a:ext>
                  </a:extLst>
                </a:gridCol>
                <a:gridCol w="481664">
                  <a:extLst>
                    <a:ext uri="{9D8B030D-6E8A-4147-A177-3AD203B41FA5}">
                      <a16:colId xmlns:a16="http://schemas.microsoft.com/office/drawing/2014/main" val="2721318606"/>
                    </a:ext>
                  </a:extLst>
                </a:gridCol>
                <a:gridCol w="481664">
                  <a:extLst>
                    <a:ext uri="{9D8B030D-6E8A-4147-A177-3AD203B41FA5}">
                      <a16:colId xmlns:a16="http://schemas.microsoft.com/office/drawing/2014/main" val="3661471882"/>
                    </a:ext>
                  </a:extLst>
                </a:gridCol>
                <a:gridCol w="481664">
                  <a:extLst>
                    <a:ext uri="{9D8B030D-6E8A-4147-A177-3AD203B41FA5}">
                      <a16:colId xmlns:a16="http://schemas.microsoft.com/office/drawing/2014/main" val="3688345384"/>
                    </a:ext>
                  </a:extLst>
                </a:gridCol>
                <a:gridCol w="481664">
                  <a:extLst>
                    <a:ext uri="{9D8B030D-6E8A-4147-A177-3AD203B41FA5}">
                      <a16:colId xmlns:a16="http://schemas.microsoft.com/office/drawing/2014/main" val="4184165124"/>
                    </a:ext>
                  </a:extLst>
                </a:gridCol>
                <a:gridCol w="481664">
                  <a:extLst>
                    <a:ext uri="{9D8B030D-6E8A-4147-A177-3AD203B41FA5}">
                      <a16:colId xmlns:a16="http://schemas.microsoft.com/office/drawing/2014/main" val="3096425814"/>
                    </a:ext>
                  </a:extLst>
                </a:gridCol>
                <a:gridCol w="481664">
                  <a:extLst>
                    <a:ext uri="{9D8B030D-6E8A-4147-A177-3AD203B41FA5}">
                      <a16:colId xmlns:a16="http://schemas.microsoft.com/office/drawing/2014/main" val="3397419283"/>
                    </a:ext>
                  </a:extLst>
                </a:gridCol>
                <a:gridCol w="481664">
                  <a:extLst>
                    <a:ext uri="{9D8B030D-6E8A-4147-A177-3AD203B41FA5}">
                      <a16:colId xmlns:a16="http://schemas.microsoft.com/office/drawing/2014/main" val="2041993592"/>
                    </a:ext>
                  </a:extLst>
                </a:gridCol>
                <a:gridCol w="481664">
                  <a:extLst>
                    <a:ext uri="{9D8B030D-6E8A-4147-A177-3AD203B41FA5}">
                      <a16:colId xmlns:a16="http://schemas.microsoft.com/office/drawing/2014/main" val="377896078"/>
                    </a:ext>
                  </a:extLst>
                </a:gridCol>
                <a:gridCol w="481664">
                  <a:extLst>
                    <a:ext uri="{9D8B030D-6E8A-4147-A177-3AD203B41FA5}">
                      <a16:colId xmlns:a16="http://schemas.microsoft.com/office/drawing/2014/main" val="3674504101"/>
                    </a:ext>
                  </a:extLst>
                </a:gridCol>
                <a:gridCol w="481664">
                  <a:extLst>
                    <a:ext uri="{9D8B030D-6E8A-4147-A177-3AD203B41FA5}">
                      <a16:colId xmlns:a16="http://schemas.microsoft.com/office/drawing/2014/main" val="1946901478"/>
                    </a:ext>
                  </a:extLst>
                </a:gridCol>
              </a:tblGrid>
              <a:tr h="326421">
                <a:tc>
                  <a:txBody>
                    <a:bodyPr/>
                    <a:lstStyle/>
                    <a:p>
                      <a:r>
                        <a:rPr lang="en-US" dirty="0" err="1" smtClean="0"/>
                        <a:t>Coc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50499145"/>
                  </a:ext>
                </a:extLst>
              </a:tr>
              <a:tr h="326421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14755554"/>
                  </a:ext>
                </a:extLst>
              </a:tr>
              <a:tr h="326421"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24046044"/>
                  </a:ext>
                </a:extLst>
              </a:tr>
              <a:tr h="326421"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5356198"/>
                  </a:ext>
                </a:extLst>
              </a:tr>
              <a:tr h="326421"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7487379"/>
                  </a:ext>
                </a:extLst>
              </a:tr>
              <a:tr h="326421"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69</a:t>
                      </a: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4128871"/>
                  </a:ext>
                </a:extLst>
              </a:tr>
              <a:tr h="326421"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01593134"/>
                  </a:ext>
                </a:extLst>
              </a:tr>
              <a:tr h="326421"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61</a:t>
                      </a: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7645561"/>
                  </a:ext>
                </a:extLst>
              </a:tr>
              <a:tr h="326421"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28</a:t>
                      </a: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5816942"/>
                  </a:ext>
                </a:extLst>
              </a:tr>
              <a:tr h="326421"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39645725"/>
                  </a:ext>
                </a:extLst>
              </a:tr>
              <a:tr h="326421"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83516937"/>
                  </a:ext>
                </a:extLst>
              </a:tr>
              <a:tr h="326421"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41858448"/>
                  </a:ext>
                </a:extLst>
              </a:tr>
              <a:tr h="326421"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34260543"/>
                  </a:ext>
                </a:extLst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-1" y="39064"/>
            <a:ext cx="39824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6 </a:t>
            </a:r>
            <a:r>
              <a:rPr lang="en-US" dirty="0" smtClean="0"/>
              <a:t>Astrocyte mean amplitudes KW test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634664" y="764061"/>
            <a:ext cx="2045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W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0" y="1359569"/>
            <a:ext cx="11670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smooth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-21056" y="2573528"/>
            <a:ext cx="120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minimal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18046" y="3838879"/>
            <a:ext cx="12332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initial</a:t>
            </a:r>
            <a:endParaRPr lang="en-US" dirty="0"/>
          </a:p>
        </p:txBody>
      </p:sp>
      <p:sp>
        <p:nvSpPr>
          <p:cNvPr id="12" name="Left Brace 11"/>
          <p:cNvSpPr/>
          <p:nvPr/>
        </p:nvSpPr>
        <p:spPr>
          <a:xfrm>
            <a:off x="1205563" y="1151385"/>
            <a:ext cx="45719" cy="857889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Left Brace 12"/>
          <p:cNvSpPr/>
          <p:nvPr/>
        </p:nvSpPr>
        <p:spPr>
          <a:xfrm>
            <a:off x="1190224" y="2362748"/>
            <a:ext cx="45719" cy="857889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Left Brace 13"/>
          <p:cNvSpPr/>
          <p:nvPr/>
        </p:nvSpPr>
        <p:spPr>
          <a:xfrm>
            <a:off x="1182703" y="3594600"/>
            <a:ext cx="45719" cy="857889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Left Brace 14"/>
          <p:cNvSpPr/>
          <p:nvPr/>
        </p:nvSpPr>
        <p:spPr>
          <a:xfrm>
            <a:off x="1118335" y="830123"/>
            <a:ext cx="128735" cy="237208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extBox 15"/>
          <p:cNvSpPr txBox="1"/>
          <p:nvPr/>
        </p:nvSpPr>
        <p:spPr>
          <a:xfrm>
            <a:off x="654712" y="5500505"/>
            <a:ext cx="2045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W</a:t>
            </a:r>
            <a:endParaRPr 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20048" y="6096013"/>
            <a:ext cx="11670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smooth</a:t>
            </a:r>
            <a:endParaRPr lang="en-US" dirty="0"/>
          </a:p>
        </p:txBody>
      </p:sp>
      <p:sp>
        <p:nvSpPr>
          <p:cNvPr id="18" name="TextBox 17"/>
          <p:cNvSpPr txBox="1"/>
          <p:nvPr/>
        </p:nvSpPr>
        <p:spPr>
          <a:xfrm>
            <a:off x="-1008" y="7309972"/>
            <a:ext cx="120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minimal</a:t>
            </a:r>
            <a:endParaRPr lang="en-US" dirty="0"/>
          </a:p>
        </p:txBody>
      </p:sp>
      <p:sp>
        <p:nvSpPr>
          <p:cNvPr id="19" name="TextBox 18"/>
          <p:cNvSpPr txBox="1"/>
          <p:nvPr/>
        </p:nvSpPr>
        <p:spPr>
          <a:xfrm>
            <a:off x="38094" y="8575323"/>
            <a:ext cx="12332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initial</a:t>
            </a:r>
            <a:endParaRPr lang="en-US" dirty="0"/>
          </a:p>
        </p:txBody>
      </p:sp>
      <p:sp>
        <p:nvSpPr>
          <p:cNvPr id="20" name="Left Brace 19"/>
          <p:cNvSpPr/>
          <p:nvPr/>
        </p:nvSpPr>
        <p:spPr>
          <a:xfrm>
            <a:off x="1225611" y="5887829"/>
            <a:ext cx="45719" cy="857889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Left Brace 20"/>
          <p:cNvSpPr/>
          <p:nvPr/>
        </p:nvSpPr>
        <p:spPr>
          <a:xfrm>
            <a:off x="1210272" y="7099192"/>
            <a:ext cx="45719" cy="857889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Left Brace 21"/>
          <p:cNvSpPr/>
          <p:nvPr/>
        </p:nvSpPr>
        <p:spPr>
          <a:xfrm>
            <a:off x="1202751" y="8331044"/>
            <a:ext cx="45719" cy="857889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Left Brace 22"/>
          <p:cNvSpPr/>
          <p:nvPr/>
        </p:nvSpPr>
        <p:spPr>
          <a:xfrm>
            <a:off x="1138383" y="5566567"/>
            <a:ext cx="128735" cy="237208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TextBox 23"/>
          <p:cNvSpPr txBox="1"/>
          <p:nvPr/>
        </p:nvSpPr>
        <p:spPr>
          <a:xfrm>
            <a:off x="1820964" y="4772204"/>
            <a:ext cx="3609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W</a:t>
            </a:r>
            <a:endParaRPr lang="en-US" dirty="0"/>
          </a:p>
        </p:txBody>
      </p:sp>
      <p:sp>
        <p:nvSpPr>
          <p:cNvPr id="25" name="TextBox 24"/>
          <p:cNvSpPr txBox="1"/>
          <p:nvPr/>
        </p:nvSpPr>
        <p:spPr>
          <a:xfrm>
            <a:off x="2430378" y="4772204"/>
            <a:ext cx="12753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smooth</a:t>
            </a:r>
            <a:endParaRPr lang="en-US" dirty="0"/>
          </a:p>
        </p:txBody>
      </p:sp>
      <p:sp>
        <p:nvSpPr>
          <p:cNvPr id="26" name="TextBox 25"/>
          <p:cNvSpPr txBox="1"/>
          <p:nvPr/>
        </p:nvSpPr>
        <p:spPr>
          <a:xfrm>
            <a:off x="4018548" y="4772204"/>
            <a:ext cx="1660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minimal</a:t>
            </a:r>
            <a:endParaRPr lang="en-US" dirty="0"/>
          </a:p>
        </p:txBody>
      </p:sp>
      <p:sp>
        <p:nvSpPr>
          <p:cNvPr id="27" name="TextBox 26"/>
          <p:cNvSpPr txBox="1"/>
          <p:nvPr/>
        </p:nvSpPr>
        <p:spPr>
          <a:xfrm>
            <a:off x="5955632" y="4772204"/>
            <a:ext cx="12272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initial</a:t>
            </a:r>
            <a:endParaRPr lang="en-US" dirty="0"/>
          </a:p>
        </p:txBody>
      </p:sp>
      <p:sp>
        <p:nvSpPr>
          <p:cNvPr id="28" name="Left Brace 27"/>
          <p:cNvSpPr/>
          <p:nvPr/>
        </p:nvSpPr>
        <p:spPr>
          <a:xfrm rot="16200000">
            <a:off x="1991373" y="4584235"/>
            <a:ext cx="60740" cy="330433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Left Brace 28"/>
          <p:cNvSpPr/>
          <p:nvPr/>
        </p:nvSpPr>
        <p:spPr>
          <a:xfrm rot="5400000">
            <a:off x="1982765" y="4944369"/>
            <a:ext cx="63902" cy="330433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Left Brace 29"/>
          <p:cNvSpPr/>
          <p:nvPr/>
        </p:nvSpPr>
        <p:spPr>
          <a:xfrm rot="16200000">
            <a:off x="2980415" y="4278007"/>
            <a:ext cx="45719" cy="1025474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Left Brace 30"/>
          <p:cNvSpPr/>
          <p:nvPr/>
        </p:nvSpPr>
        <p:spPr>
          <a:xfrm rot="16200000">
            <a:off x="4665702" y="4085871"/>
            <a:ext cx="53230" cy="1419731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Left Brace 31"/>
          <p:cNvSpPr/>
          <p:nvPr/>
        </p:nvSpPr>
        <p:spPr>
          <a:xfrm rot="16200000">
            <a:off x="6546384" y="4185881"/>
            <a:ext cx="45720" cy="1227223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Left Brace 32"/>
          <p:cNvSpPr/>
          <p:nvPr/>
        </p:nvSpPr>
        <p:spPr>
          <a:xfrm rot="5400000">
            <a:off x="2975723" y="4601249"/>
            <a:ext cx="55102" cy="1025475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Left Brace 33"/>
          <p:cNvSpPr/>
          <p:nvPr/>
        </p:nvSpPr>
        <p:spPr>
          <a:xfrm rot="5400000">
            <a:off x="4644160" y="4429680"/>
            <a:ext cx="96314" cy="1419732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Left Brace 34"/>
          <p:cNvSpPr/>
          <p:nvPr/>
        </p:nvSpPr>
        <p:spPr>
          <a:xfrm rot="5400000">
            <a:off x="6562216" y="4520901"/>
            <a:ext cx="50148" cy="1191123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TextBox 35"/>
          <p:cNvSpPr txBox="1"/>
          <p:nvPr/>
        </p:nvSpPr>
        <p:spPr>
          <a:xfrm>
            <a:off x="963169" y="9607296"/>
            <a:ext cx="65926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olored boxes indicate significant differences by </a:t>
            </a:r>
            <a:r>
              <a:rPr lang="en-US" dirty="0" err="1" smtClean="0"/>
              <a:t>Kruskal</a:t>
            </a:r>
            <a:r>
              <a:rPr lang="en-US" dirty="0" smtClean="0"/>
              <a:t>-Wallis test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1478193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30103718"/>
              </p:ext>
            </p:extLst>
          </p:nvPr>
        </p:nvGraphicFramePr>
        <p:xfrm>
          <a:off x="1285568" y="446497"/>
          <a:ext cx="6296328" cy="422074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47698">
                  <a:extLst>
                    <a:ext uri="{9D8B030D-6E8A-4147-A177-3AD203B41FA5}">
                      <a16:colId xmlns:a16="http://schemas.microsoft.com/office/drawing/2014/main" val="4205108466"/>
                    </a:ext>
                  </a:extLst>
                </a:gridCol>
                <a:gridCol w="511966">
                  <a:extLst>
                    <a:ext uri="{9D8B030D-6E8A-4147-A177-3AD203B41FA5}">
                      <a16:colId xmlns:a16="http://schemas.microsoft.com/office/drawing/2014/main" val="1878353026"/>
                    </a:ext>
                  </a:extLst>
                </a:gridCol>
                <a:gridCol w="493334">
                  <a:extLst>
                    <a:ext uri="{9D8B030D-6E8A-4147-A177-3AD203B41FA5}">
                      <a16:colId xmlns:a16="http://schemas.microsoft.com/office/drawing/2014/main" val="3731821567"/>
                    </a:ext>
                  </a:extLst>
                </a:gridCol>
                <a:gridCol w="484333">
                  <a:extLst>
                    <a:ext uri="{9D8B030D-6E8A-4147-A177-3AD203B41FA5}">
                      <a16:colId xmlns:a16="http://schemas.microsoft.com/office/drawing/2014/main" val="2721318606"/>
                    </a:ext>
                  </a:extLst>
                </a:gridCol>
                <a:gridCol w="484333">
                  <a:extLst>
                    <a:ext uri="{9D8B030D-6E8A-4147-A177-3AD203B41FA5}">
                      <a16:colId xmlns:a16="http://schemas.microsoft.com/office/drawing/2014/main" val="3661471882"/>
                    </a:ext>
                  </a:extLst>
                </a:gridCol>
                <a:gridCol w="484333">
                  <a:extLst>
                    <a:ext uri="{9D8B030D-6E8A-4147-A177-3AD203B41FA5}">
                      <a16:colId xmlns:a16="http://schemas.microsoft.com/office/drawing/2014/main" val="3688345384"/>
                    </a:ext>
                  </a:extLst>
                </a:gridCol>
                <a:gridCol w="484333">
                  <a:extLst>
                    <a:ext uri="{9D8B030D-6E8A-4147-A177-3AD203B41FA5}">
                      <a16:colId xmlns:a16="http://schemas.microsoft.com/office/drawing/2014/main" val="4184165124"/>
                    </a:ext>
                  </a:extLst>
                </a:gridCol>
                <a:gridCol w="484333">
                  <a:extLst>
                    <a:ext uri="{9D8B030D-6E8A-4147-A177-3AD203B41FA5}">
                      <a16:colId xmlns:a16="http://schemas.microsoft.com/office/drawing/2014/main" val="3096425814"/>
                    </a:ext>
                  </a:extLst>
                </a:gridCol>
                <a:gridCol w="484333">
                  <a:extLst>
                    <a:ext uri="{9D8B030D-6E8A-4147-A177-3AD203B41FA5}">
                      <a16:colId xmlns:a16="http://schemas.microsoft.com/office/drawing/2014/main" val="3397419283"/>
                    </a:ext>
                  </a:extLst>
                </a:gridCol>
                <a:gridCol w="484333">
                  <a:extLst>
                    <a:ext uri="{9D8B030D-6E8A-4147-A177-3AD203B41FA5}">
                      <a16:colId xmlns:a16="http://schemas.microsoft.com/office/drawing/2014/main" val="2041993592"/>
                    </a:ext>
                  </a:extLst>
                </a:gridCol>
                <a:gridCol w="484333">
                  <a:extLst>
                    <a:ext uri="{9D8B030D-6E8A-4147-A177-3AD203B41FA5}">
                      <a16:colId xmlns:a16="http://schemas.microsoft.com/office/drawing/2014/main" val="377896078"/>
                    </a:ext>
                  </a:extLst>
                </a:gridCol>
                <a:gridCol w="484333">
                  <a:extLst>
                    <a:ext uri="{9D8B030D-6E8A-4147-A177-3AD203B41FA5}">
                      <a16:colId xmlns:a16="http://schemas.microsoft.com/office/drawing/2014/main" val="3674504101"/>
                    </a:ext>
                  </a:extLst>
                </a:gridCol>
                <a:gridCol w="484333">
                  <a:extLst>
                    <a:ext uri="{9D8B030D-6E8A-4147-A177-3AD203B41FA5}">
                      <a16:colId xmlns:a16="http://schemas.microsoft.com/office/drawing/2014/main" val="1946901478"/>
                    </a:ext>
                  </a:extLst>
                </a:gridCol>
              </a:tblGrid>
              <a:tr h="324673">
                <a:tc>
                  <a:txBody>
                    <a:bodyPr/>
                    <a:lstStyle/>
                    <a:p>
                      <a:r>
                        <a:rPr lang="en-US" dirty="0" smtClean="0"/>
                        <a:t>Sal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50499145"/>
                  </a:ext>
                </a:extLst>
              </a:tr>
              <a:tr h="324673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14755554"/>
                  </a:ext>
                </a:extLst>
              </a:tr>
              <a:tr h="324673"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24046044"/>
                  </a:ext>
                </a:extLst>
              </a:tr>
              <a:tr h="324673"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5356198"/>
                  </a:ext>
                </a:extLst>
              </a:tr>
              <a:tr h="324673"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7487379"/>
                  </a:ext>
                </a:extLst>
              </a:tr>
              <a:tr h="324673"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0007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4128871"/>
                  </a:ext>
                </a:extLst>
              </a:tr>
              <a:tr h="324673"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01593134"/>
                  </a:ext>
                </a:extLst>
              </a:tr>
              <a:tr h="324673"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0016</a:t>
                      </a: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7645561"/>
                  </a:ext>
                </a:extLst>
              </a:tr>
              <a:tr h="324673"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5816942"/>
                  </a:ext>
                </a:extLst>
              </a:tr>
              <a:tr h="324673"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39645725"/>
                  </a:ext>
                </a:extLst>
              </a:tr>
              <a:tr h="324673"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0020</a:t>
                      </a: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83516937"/>
                  </a:ext>
                </a:extLst>
              </a:tr>
              <a:tr h="324673"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41858448"/>
                  </a:ext>
                </a:extLst>
              </a:tr>
              <a:tr h="324673"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34260543"/>
                  </a:ext>
                </a:extLst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63124593"/>
              </p:ext>
            </p:extLst>
          </p:nvPr>
        </p:nvGraphicFramePr>
        <p:xfrm>
          <a:off x="1305613" y="5227762"/>
          <a:ext cx="6276283" cy="421995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82791">
                  <a:extLst>
                    <a:ext uri="{9D8B030D-6E8A-4147-A177-3AD203B41FA5}">
                      <a16:colId xmlns:a16="http://schemas.microsoft.com/office/drawing/2014/main" val="4205108466"/>
                    </a:ext>
                  </a:extLst>
                </a:gridCol>
                <a:gridCol w="482791">
                  <a:extLst>
                    <a:ext uri="{9D8B030D-6E8A-4147-A177-3AD203B41FA5}">
                      <a16:colId xmlns:a16="http://schemas.microsoft.com/office/drawing/2014/main" val="1878353026"/>
                    </a:ext>
                  </a:extLst>
                </a:gridCol>
                <a:gridCol w="482791">
                  <a:extLst>
                    <a:ext uri="{9D8B030D-6E8A-4147-A177-3AD203B41FA5}">
                      <a16:colId xmlns:a16="http://schemas.microsoft.com/office/drawing/2014/main" val="3731821567"/>
                    </a:ext>
                  </a:extLst>
                </a:gridCol>
                <a:gridCol w="482791">
                  <a:extLst>
                    <a:ext uri="{9D8B030D-6E8A-4147-A177-3AD203B41FA5}">
                      <a16:colId xmlns:a16="http://schemas.microsoft.com/office/drawing/2014/main" val="2721318606"/>
                    </a:ext>
                  </a:extLst>
                </a:gridCol>
                <a:gridCol w="482791">
                  <a:extLst>
                    <a:ext uri="{9D8B030D-6E8A-4147-A177-3AD203B41FA5}">
                      <a16:colId xmlns:a16="http://schemas.microsoft.com/office/drawing/2014/main" val="3661471882"/>
                    </a:ext>
                  </a:extLst>
                </a:gridCol>
                <a:gridCol w="482791">
                  <a:extLst>
                    <a:ext uri="{9D8B030D-6E8A-4147-A177-3AD203B41FA5}">
                      <a16:colId xmlns:a16="http://schemas.microsoft.com/office/drawing/2014/main" val="3688345384"/>
                    </a:ext>
                  </a:extLst>
                </a:gridCol>
                <a:gridCol w="482791">
                  <a:extLst>
                    <a:ext uri="{9D8B030D-6E8A-4147-A177-3AD203B41FA5}">
                      <a16:colId xmlns:a16="http://schemas.microsoft.com/office/drawing/2014/main" val="4184165124"/>
                    </a:ext>
                  </a:extLst>
                </a:gridCol>
                <a:gridCol w="482791">
                  <a:extLst>
                    <a:ext uri="{9D8B030D-6E8A-4147-A177-3AD203B41FA5}">
                      <a16:colId xmlns:a16="http://schemas.microsoft.com/office/drawing/2014/main" val="3096425814"/>
                    </a:ext>
                  </a:extLst>
                </a:gridCol>
                <a:gridCol w="482791">
                  <a:extLst>
                    <a:ext uri="{9D8B030D-6E8A-4147-A177-3AD203B41FA5}">
                      <a16:colId xmlns:a16="http://schemas.microsoft.com/office/drawing/2014/main" val="3397419283"/>
                    </a:ext>
                  </a:extLst>
                </a:gridCol>
                <a:gridCol w="482791">
                  <a:extLst>
                    <a:ext uri="{9D8B030D-6E8A-4147-A177-3AD203B41FA5}">
                      <a16:colId xmlns:a16="http://schemas.microsoft.com/office/drawing/2014/main" val="2041993592"/>
                    </a:ext>
                  </a:extLst>
                </a:gridCol>
                <a:gridCol w="482791">
                  <a:extLst>
                    <a:ext uri="{9D8B030D-6E8A-4147-A177-3AD203B41FA5}">
                      <a16:colId xmlns:a16="http://schemas.microsoft.com/office/drawing/2014/main" val="377896078"/>
                    </a:ext>
                  </a:extLst>
                </a:gridCol>
                <a:gridCol w="482791">
                  <a:extLst>
                    <a:ext uri="{9D8B030D-6E8A-4147-A177-3AD203B41FA5}">
                      <a16:colId xmlns:a16="http://schemas.microsoft.com/office/drawing/2014/main" val="3674504101"/>
                    </a:ext>
                  </a:extLst>
                </a:gridCol>
                <a:gridCol w="482791">
                  <a:extLst>
                    <a:ext uri="{9D8B030D-6E8A-4147-A177-3AD203B41FA5}">
                      <a16:colId xmlns:a16="http://schemas.microsoft.com/office/drawing/2014/main" val="1946901478"/>
                    </a:ext>
                  </a:extLst>
                </a:gridCol>
              </a:tblGrid>
              <a:tr h="294466">
                <a:tc>
                  <a:txBody>
                    <a:bodyPr/>
                    <a:lstStyle/>
                    <a:p>
                      <a:r>
                        <a:rPr lang="en-US" dirty="0" err="1" smtClean="0"/>
                        <a:t>Coc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50499145"/>
                  </a:ext>
                </a:extLst>
              </a:tr>
              <a:tr h="321908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14755554"/>
                  </a:ext>
                </a:extLst>
              </a:tr>
              <a:tr h="321908"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24046044"/>
                  </a:ext>
                </a:extLst>
              </a:tr>
              <a:tr h="321908"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5356198"/>
                  </a:ext>
                </a:extLst>
              </a:tr>
              <a:tr h="321908"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7487379"/>
                  </a:ext>
                </a:extLst>
              </a:tr>
              <a:tr h="321908"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4128871"/>
                  </a:ext>
                </a:extLst>
              </a:tr>
              <a:tr h="321908"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01593134"/>
                  </a:ext>
                </a:extLst>
              </a:tr>
              <a:tr h="321908"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7645561"/>
                  </a:ext>
                </a:extLst>
              </a:tr>
              <a:tr h="321908"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5816942"/>
                  </a:ext>
                </a:extLst>
              </a:tr>
              <a:tr h="321908"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0005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39645725"/>
                  </a:ext>
                </a:extLst>
              </a:tr>
              <a:tr h="321908"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0086</a:t>
                      </a: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83516937"/>
                  </a:ext>
                </a:extLst>
              </a:tr>
              <a:tr h="321908"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41858448"/>
                  </a:ext>
                </a:extLst>
              </a:tr>
              <a:tr h="321908"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34260543"/>
                  </a:ext>
                </a:extLst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-1" y="39064"/>
            <a:ext cx="39824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7 </a:t>
            </a:r>
            <a:r>
              <a:rPr lang="en-US" dirty="0" smtClean="0"/>
              <a:t>Astrocyte mean frequencies KW test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634664" y="764061"/>
            <a:ext cx="2045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W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0" y="1359569"/>
            <a:ext cx="11670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smooth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-21056" y="2573528"/>
            <a:ext cx="120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minimal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18046" y="3838879"/>
            <a:ext cx="12332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initial</a:t>
            </a:r>
            <a:endParaRPr lang="en-US" dirty="0"/>
          </a:p>
        </p:txBody>
      </p:sp>
      <p:sp>
        <p:nvSpPr>
          <p:cNvPr id="11" name="Left Brace 10"/>
          <p:cNvSpPr/>
          <p:nvPr/>
        </p:nvSpPr>
        <p:spPr>
          <a:xfrm>
            <a:off x="1205563" y="1151385"/>
            <a:ext cx="45719" cy="857889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Left Brace 11"/>
          <p:cNvSpPr/>
          <p:nvPr/>
        </p:nvSpPr>
        <p:spPr>
          <a:xfrm>
            <a:off x="1190224" y="2362748"/>
            <a:ext cx="45719" cy="857889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Left Brace 12"/>
          <p:cNvSpPr/>
          <p:nvPr/>
        </p:nvSpPr>
        <p:spPr>
          <a:xfrm>
            <a:off x="1182703" y="3594600"/>
            <a:ext cx="45719" cy="857889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Left Brace 13"/>
          <p:cNvSpPr/>
          <p:nvPr/>
        </p:nvSpPr>
        <p:spPr>
          <a:xfrm>
            <a:off x="1118335" y="830123"/>
            <a:ext cx="128735" cy="237208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/>
          <p:cNvSpPr txBox="1"/>
          <p:nvPr/>
        </p:nvSpPr>
        <p:spPr>
          <a:xfrm>
            <a:off x="654712" y="5500505"/>
            <a:ext cx="2045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W</a:t>
            </a:r>
            <a:endParaRPr 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20048" y="6096013"/>
            <a:ext cx="11670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smooth</a:t>
            </a:r>
            <a:endParaRPr 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-1008" y="7309972"/>
            <a:ext cx="120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minimal</a:t>
            </a:r>
            <a:endParaRPr lang="en-US" dirty="0"/>
          </a:p>
        </p:txBody>
      </p:sp>
      <p:sp>
        <p:nvSpPr>
          <p:cNvPr id="18" name="TextBox 17"/>
          <p:cNvSpPr txBox="1"/>
          <p:nvPr/>
        </p:nvSpPr>
        <p:spPr>
          <a:xfrm>
            <a:off x="38094" y="8575323"/>
            <a:ext cx="12332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initial</a:t>
            </a:r>
            <a:endParaRPr lang="en-US" dirty="0"/>
          </a:p>
        </p:txBody>
      </p:sp>
      <p:sp>
        <p:nvSpPr>
          <p:cNvPr id="19" name="Left Brace 18"/>
          <p:cNvSpPr/>
          <p:nvPr/>
        </p:nvSpPr>
        <p:spPr>
          <a:xfrm>
            <a:off x="1225611" y="5887829"/>
            <a:ext cx="45719" cy="857889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Left Brace 19"/>
          <p:cNvSpPr/>
          <p:nvPr/>
        </p:nvSpPr>
        <p:spPr>
          <a:xfrm>
            <a:off x="1210272" y="7099192"/>
            <a:ext cx="45719" cy="857889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Left Brace 20"/>
          <p:cNvSpPr/>
          <p:nvPr/>
        </p:nvSpPr>
        <p:spPr>
          <a:xfrm>
            <a:off x="1202751" y="8331044"/>
            <a:ext cx="45719" cy="857889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Left Brace 21"/>
          <p:cNvSpPr/>
          <p:nvPr/>
        </p:nvSpPr>
        <p:spPr>
          <a:xfrm>
            <a:off x="1138383" y="5566567"/>
            <a:ext cx="128735" cy="237208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TextBox 22"/>
          <p:cNvSpPr txBox="1"/>
          <p:nvPr/>
        </p:nvSpPr>
        <p:spPr>
          <a:xfrm>
            <a:off x="1820964" y="4772204"/>
            <a:ext cx="3609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W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2430378" y="4772204"/>
            <a:ext cx="12753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smooth</a:t>
            </a:r>
            <a:endParaRPr lang="en-US" dirty="0"/>
          </a:p>
        </p:txBody>
      </p:sp>
      <p:sp>
        <p:nvSpPr>
          <p:cNvPr id="25" name="TextBox 24"/>
          <p:cNvSpPr txBox="1"/>
          <p:nvPr/>
        </p:nvSpPr>
        <p:spPr>
          <a:xfrm>
            <a:off x="4018548" y="4772204"/>
            <a:ext cx="1660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minimal</a:t>
            </a:r>
            <a:endParaRPr lang="en-US" dirty="0"/>
          </a:p>
        </p:txBody>
      </p:sp>
      <p:sp>
        <p:nvSpPr>
          <p:cNvPr id="26" name="TextBox 25"/>
          <p:cNvSpPr txBox="1"/>
          <p:nvPr/>
        </p:nvSpPr>
        <p:spPr>
          <a:xfrm>
            <a:off x="5955632" y="4772204"/>
            <a:ext cx="12272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initial</a:t>
            </a:r>
            <a:endParaRPr lang="en-US" dirty="0"/>
          </a:p>
        </p:txBody>
      </p:sp>
      <p:sp>
        <p:nvSpPr>
          <p:cNvPr id="27" name="Left Brace 26"/>
          <p:cNvSpPr/>
          <p:nvPr/>
        </p:nvSpPr>
        <p:spPr>
          <a:xfrm rot="16200000">
            <a:off x="1991373" y="4584235"/>
            <a:ext cx="60740" cy="330433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Left Brace 27"/>
          <p:cNvSpPr/>
          <p:nvPr/>
        </p:nvSpPr>
        <p:spPr>
          <a:xfrm rot="5400000">
            <a:off x="1982765" y="4944369"/>
            <a:ext cx="63902" cy="330433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Left Brace 28"/>
          <p:cNvSpPr/>
          <p:nvPr/>
        </p:nvSpPr>
        <p:spPr>
          <a:xfrm rot="16200000">
            <a:off x="2980415" y="4278007"/>
            <a:ext cx="45719" cy="1025474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Left Brace 29"/>
          <p:cNvSpPr/>
          <p:nvPr/>
        </p:nvSpPr>
        <p:spPr>
          <a:xfrm rot="16200000">
            <a:off x="4665702" y="4085871"/>
            <a:ext cx="53230" cy="1419731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Left Brace 30"/>
          <p:cNvSpPr/>
          <p:nvPr/>
        </p:nvSpPr>
        <p:spPr>
          <a:xfrm rot="16200000">
            <a:off x="6546384" y="4185881"/>
            <a:ext cx="45720" cy="1227223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Left Brace 31"/>
          <p:cNvSpPr/>
          <p:nvPr/>
        </p:nvSpPr>
        <p:spPr>
          <a:xfrm rot="5400000">
            <a:off x="2975723" y="4601249"/>
            <a:ext cx="55102" cy="1025475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Left Brace 32"/>
          <p:cNvSpPr/>
          <p:nvPr/>
        </p:nvSpPr>
        <p:spPr>
          <a:xfrm rot="5400000">
            <a:off x="4644160" y="4429680"/>
            <a:ext cx="96314" cy="1419732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Left Brace 33"/>
          <p:cNvSpPr/>
          <p:nvPr/>
        </p:nvSpPr>
        <p:spPr>
          <a:xfrm rot="5400000">
            <a:off x="6562216" y="4520901"/>
            <a:ext cx="50148" cy="1191123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TextBox 34"/>
          <p:cNvSpPr txBox="1"/>
          <p:nvPr/>
        </p:nvSpPr>
        <p:spPr>
          <a:xfrm>
            <a:off x="963169" y="9607296"/>
            <a:ext cx="65926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olored boxes indicate significant differences by </a:t>
            </a:r>
            <a:r>
              <a:rPr lang="en-US" dirty="0" err="1" smtClean="0"/>
              <a:t>Kruskal</a:t>
            </a:r>
            <a:r>
              <a:rPr lang="en-US" dirty="0" smtClean="0"/>
              <a:t>-Wallis test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4799586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14282036"/>
              </p:ext>
            </p:extLst>
          </p:nvPr>
        </p:nvGraphicFramePr>
        <p:xfrm>
          <a:off x="1285570" y="466515"/>
          <a:ext cx="6277271" cy="421995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82867">
                  <a:extLst>
                    <a:ext uri="{9D8B030D-6E8A-4147-A177-3AD203B41FA5}">
                      <a16:colId xmlns:a16="http://schemas.microsoft.com/office/drawing/2014/main" val="4205108466"/>
                    </a:ext>
                  </a:extLst>
                </a:gridCol>
                <a:gridCol w="482867">
                  <a:extLst>
                    <a:ext uri="{9D8B030D-6E8A-4147-A177-3AD203B41FA5}">
                      <a16:colId xmlns:a16="http://schemas.microsoft.com/office/drawing/2014/main" val="1878353026"/>
                    </a:ext>
                  </a:extLst>
                </a:gridCol>
                <a:gridCol w="482867">
                  <a:extLst>
                    <a:ext uri="{9D8B030D-6E8A-4147-A177-3AD203B41FA5}">
                      <a16:colId xmlns:a16="http://schemas.microsoft.com/office/drawing/2014/main" val="3731821567"/>
                    </a:ext>
                  </a:extLst>
                </a:gridCol>
                <a:gridCol w="482867">
                  <a:extLst>
                    <a:ext uri="{9D8B030D-6E8A-4147-A177-3AD203B41FA5}">
                      <a16:colId xmlns:a16="http://schemas.microsoft.com/office/drawing/2014/main" val="2721318606"/>
                    </a:ext>
                  </a:extLst>
                </a:gridCol>
                <a:gridCol w="482867">
                  <a:extLst>
                    <a:ext uri="{9D8B030D-6E8A-4147-A177-3AD203B41FA5}">
                      <a16:colId xmlns:a16="http://schemas.microsoft.com/office/drawing/2014/main" val="3661471882"/>
                    </a:ext>
                  </a:extLst>
                </a:gridCol>
                <a:gridCol w="482867">
                  <a:extLst>
                    <a:ext uri="{9D8B030D-6E8A-4147-A177-3AD203B41FA5}">
                      <a16:colId xmlns:a16="http://schemas.microsoft.com/office/drawing/2014/main" val="3688345384"/>
                    </a:ext>
                  </a:extLst>
                </a:gridCol>
                <a:gridCol w="482867">
                  <a:extLst>
                    <a:ext uri="{9D8B030D-6E8A-4147-A177-3AD203B41FA5}">
                      <a16:colId xmlns:a16="http://schemas.microsoft.com/office/drawing/2014/main" val="4184165124"/>
                    </a:ext>
                  </a:extLst>
                </a:gridCol>
                <a:gridCol w="482867">
                  <a:extLst>
                    <a:ext uri="{9D8B030D-6E8A-4147-A177-3AD203B41FA5}">
                      <a16:colId xmlns:a16="http://schemas.microsoft.com/office/drawing/2014/main" val="3096425814"/>
                    </a:ext>
                  </a:extLst>
                </a:gridCol>
                <a:gridCol w="482867">
                  <a:extLst>
                    <a:ext uri="{9D8B030D-6E8A-4147-A177-3AD203B41FA5}">
                      <a16:colId xmlns:a16="http://schemas.microsoft.com/office/drawing/2014/main" val="3397419283"/>
                    </a:ext>
                  </a:extLst>
                </a:gridCol>
                <a:gridCol w="482867">
                  <a:extLst>
                    <a:ext uri="{9D8B030D-6E8A-4147-A177-3AD203B41FA5}">
                      <a16:colId xmlns:a16="http://schemas.microsoft.com/office/drawing/2014/main" val="2041993592"/>
                    </a:ext>
                  </a:extLst>
                </a:gridCol>
                <a:gridCol w="482867">
                  <a:extLst>
                    <a:ext uri="{9D8B030D-6E8A-4147-A177-3AD203B41FA5}">
                      <a16:colId xmlns:a16="http://schemas.microsoft.com/office/drawing/2014/main" val="377896078"/>
                    </a:ext>
                  </a:extLst>
                </a:gridCol>
                <a:gridCol w="482867">
                  <a:extLst>
                    <a:ext uri="{9D8B030D-6E8A-4147-A177-3AD203B41FA5}">
                      <a16:colId xmlns:a16="http://schemas.microsoft.com/office/drawing/2014/main" val="3674504101"/>
                    </a:ext>
                  </a:extLst>
                </a:gridCol>
                <a:gridCol w="482867">
                  <a:extLst>
                    <a:ext uri="{9D8B030D-6E8A-4147-A177-3AD203B41FA5}">
                      <a16:colId xmlns:a16="http://schemas.microsoft.com/office/drawing/2014/main" val="1946901478"/>
                    </a:ext>
                  </a:extLst>
                </a:gridCol>
              </a:tblGrid>
              <a:tr h="320203">
                <a:tc>
                  <a:txBody>
                    <a:bodyPr/>
                    <a:lstStyle/>
                    <a:p>
                      <a:r>
                        <a:rPr lang="en-US" dirty="0" smtClean="0"/>
                        <a:t>Sal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50499145"/>
                  </a:ext>
                </a:extLst>
              </a:tr>
              <a:tr h="320203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14755554"/>
                  </a:ext>
                </a:extLst>
              </a:tr>
              <a:tr h="320203"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24046044"/>
                  </a:ext>
                </a:extLst>
              </a:tr>
              <a:tr h="320203"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5356198"/>
                  </a:ext>
                </a:extLst>
              </a:tr>
              <a:tr h="320203"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7487379"/>
                  </a:ext>
                </a:extLst>
              </a:tr>
              <a:tr h="320203"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4128871"/>
                  </a:ext>
                </a:extLst>
              </a:tr>
              <a:tr h="320203"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01593134"/>
                  </a:ext>
                </a:extLst>
              </a:tr>
              <a:tr h="320203"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7645561"/>
                  </a:ext>
                </a:extLst>
              </a:tr>
              <a:tr h="320203"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369</a:t>
                      </a:r>
                    </a:p>
                  </a:txBody>
                  <a:tcPr marL="9525" marR="9525" marT="9525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11</a:t>
                      </a: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354</a:t>
                      </a:r>
                    </a:p>
                  </a:txBody>
                  <a:tcPr marL="9525" marR="9525" marT="9525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5816942"/>
                  </a:ext>
                </a:extLst>
              </a:tr>
              <a:tr h="320203"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39645725"/>
                  </a:ext>
                </a:extLst>
              </a:tr>
              <a:tr h="320203"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83516937"/>
                  </a:ext>
                </a:extLst>
              </a:tr>
              <a:tr h="320203"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41858448"/>
                  </a:ext>
                </a:extLst>
              </a:tr>
              <a:tr h="320203"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369</a:t>
                      </a:r>
                    </a:p>
                  </a:txBody>
                  <a:tcPr marL="9525" marR="9525" marT="9525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11</a:t>
                      </a: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354</a:t>
                      </a:r>
                    </a:p>
                  </a:txBody>
                  <a:tcPr marL="9525" marR="9525" marT="9525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34260543"/>
                  </a:ext>
                </a:extLst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5309808"/>
              </p:ext>
            </p:extLst>
          </p:nvPr>
        </p:nvGraphicFramePr>
        <p:xfrm>
          <a:off x="1305621" y="5223667"/>
          <a:ext cx="6257225" cy="421995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81325">
                  <a:extLst>
                    <a:ext uri="{9D8B030D-6E8A-4147-A177-3AD203B41FA5}">
                      <a16:colId xmlns:a16="http://schemas.microsoft.com/office/drawing/2014/main" val="4205108466"/>
                    </a:ext>
                  </a:extLst>
                </a:gridCol>
                <a:gridCol w="481325">
                  <a:extLst>
                    <a:ext uri="{9D8B030D-6E8A-4147-A177-3AD203B41FA5}">
                      <a16:colId xmlns:a16="http://schemas.microsoft.com/office/drawing/2014/main" val="1878353026"/>
                    </a:ext>
                  </a:extLst>
                </a:gridCol>
                <a:gridCol w="479540">
                  <a:extLst>
                    <a:ext uri="{9D8B030D-6E8A-4147-A177-3AD203B41FA5}">
                      <a16:colId xmlns:a16="http://schemas.microsoft.com/office/drawing/2014/main" val="3731821567"/>
                    </a:ext>
                  </a:extLst>
                </a:gridCol>
                <a:gridCol w="483110">
                  <a:extLst>
                    <a:ext uri="{9D8B030D-6E8A-4147-A177-3AD203B41FA5}">
                      <a16:colId xmlns:a16="http://schemas.microsoft.com/office/drawing/2014/main" val="2721318606"/>
                    </a:ext>
                  </a:extLst>
                </a:gridCol>
                <a:gridCol w="481325">
                  <a:extLst>
                    <a:ext uri="{9D8B030D-6E8A-4147-A177-3AD203B41FA5}">
                      <a16:colId xmlns:a16="http://schemas.microsoft.com/office/drawing/2014/main" val="3661471882"/>
                    </a:ext>
                  </a:extLst>
                </a:gridCol>
                <a:gridCol w="481325">
                  <a:extLst>
                    <a:ext uri="{9D8B030D-6E8A-4147-A177-3AD203B41FA5}">
                      <a16:colId xmlns:a16="http://schemas.microsoft.com/office/drawing/2014/main" val="3688345384"/>
                    </a:ext>
                  </a:extLst>
                </a:gridCol>
                <a:gridCol w="481325">
                  <a:extLst>
                    <a:ext uri="{9D8B030D-6E8A-4147-A177-3AD203B41FA5}">
                      <a16:colId xmlns:a16="http://schemas.microsoft.com/office/drawing/2014/main" val="4184165124"/>
                    </a:ext>
                  </a:extLst>
                </a:gridCol>
                <a:gridCol w="481325">
                  <a:extLst>
                    <a:ext uri="{9D8B030D-6E8A-4147-A177-3AD203B41FA5}">
                      <a16:colId xmlns:a16="http://schemas.microsoft.com/office/drawing/2014/main" val="3096425814"/>
                    </a:ext>
                  </a:extLst>
                </a:gridCol>
                <a:gridCol w="481325">
                  <a:extLst>
                    <a:ext uri="{9D8B030D-6E8A-4147-A177-3AD203B41FA5}">
                      <a16:colId xmlns:a16="http://schemas.microsoft.com/office/drawing/2014/main" val="3397419283"/>
                    </a:ext>
                  </a:extLst>
                </a:gridCol>
                <a:gridCol w="481325">
                  <a:extLst>
                    <a:ext uri="{9D8B030D-6E8A-4147-A177-3AD203B41FA5}">
                      <a16:colId xmlns:a16="http://schemas.microsoft.com/office/drawing/2014/main" val="2041993592"/>
                    </a:ext>
                  </a:extLst>
                </a:gridCol>
                <a:gridCol w="481325">
                  <a:extLst>
                    <a:ext uri="{9D8B030D-6E8A-4147-A177-3AD203B41FA5}">
                      <a16:colId xmlns:a16="http://schemas.microsoft.com/office/drawing/2014/main" val="377896078"/>
                    </a:ext>
                  </a:extLst>
                </a:gridCol>
                <a:gridCol w="481325">
                  <a:extLst>
                    <a:ext uri="{9D8B030D-6E8A-4147-A177-3AD203B41FA5}">
                      <a16:colId xmlns:a16="http://schemas.microsoft.com/office/drawing/2014/main" val="3674504101"/>
                    </a:ext>
                  </a:extLst>
                </a:gridCol>
                <a:gridCol w="481325">
                  <a:extLst>
                    <a:ext uri="{9D8B030D-6E8A-4147-A177-3AD203B41FA5}">
                      <a16:colId xmlns:a16="http://schemas.microsoft.com/office/drawing/2014/main" val="1946901478"/>
                    </a:ext>
                  </a:extLst>
                </a:gridCol>
              </a:tblGrid>
              <a:tr h="305150">
                <a:tc>
                  <a:txBody>
                    <a:bodyPr/>
                    <a:lstStyle/>
                    <a:p>
                      <a:r>
                        <a:rPr lang="en-US" dirty="0" err="1" smtClean="0"/>
                        <a:t>Coc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50499145"/>
                  </a:ext>
                </a:extLst>
              </a:tr>
              <a:tr h="30515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14755554"/>
                  </a:ext>
                </a:extLst>
              </a:tr>
              <a:tr h="305150"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24046044"/>
                  </a:ext>
                </a:extLst>
              </a:tr>
              <a:tr h="305150"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5356198"/>
                  </a:ext>
                </a:extLst>
              </a:tr>
              <a:tr h="305150"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7487379"/>
                  </a:ext>
                </a:extLst>
              </a:tr>
              <a:tr h="305150"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4128871"/>
                  </a:ext>
                </a:extLst>
              </a:tr>
              <a:tr h="305150"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5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108</a:t>
                      </a:r>
                    </a:p>
                  </a:txBody>
                  <a:tcPr marL="9525" marR="9525" marT="9525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01593134"/>
                  </a:ext>
                </a:extLst>
              </a:tr>
              <a:tr h="305150"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7645561"/>
                  </a:ext>
                </a:extLst>
              </a:tr>
              <a:tr h="305150"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14</a:t>
                      </a: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5816942"/>
                  </a:ext>
                </a:extLst>
              </a:tr>
              <a:tr h="305150">
                <a:tc>
                  <a:txBody>
                    <a:bodyPr/>
                    <a:lstStyle/>
                    <a:p>
                      <a:r>
                        <a:rPr lang="en-US" dirty="0" smtClean="0"/>
                        <a:t>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39645725"/>
                  </a:ext>
                </a:extLst>
              </a:tr>
              <a:tr h="305150">
                <a:tc>
                  <a:txBody>
                    <a:bodyPr/>
                    <a:lstStyle/>
                    <a:p>
                      <a:r>
                        <a:rPr lang="en-US" dirty="0" smtClean="0"/>
                        <a:t>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83516937"/>
                  </a:ext>
                </a:extLst>
              </a:tr>
              <a:tr h="305150">
                <a:tc>
                  <a:txBody>
                    <a:bodyPr/>
                    <a:lstStyle/>
                    <a:p>
                      <a:r>
                        <a:rPr lang="en-US" dirty="0" smtClean="0"/>
                        <a:t>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41858448"/>
                  </a:ext>
                </a:extLst>
              </a:tr>
              <a:tr h="305150">
                <a:tc>
                  <a:txBody>
                    <a:bodyPr/>
                    <a:lstStyle/>
                    <a:p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14</a:t>
                      </a: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34260543"/>
                  </a:ext>
                </a:extLst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-1" y="39064"/>
            <a:ext cx="37057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8 </a:t>
            </a:r>
            <a:r>
              <a:rPr lang="en-US" dirty="0" smtClean="0"/>
              <a:t>Astrocyte mean durations KW test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634664" y="764061"/>
            <a:ext cx="2045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W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0" y="1359569"/>
            <a:ext cx="11670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smooth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-21056" y="2573528"/>
            <a:ext cx="120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minimal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18046" y="3838879"/>
            <a:ext cx="12332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initial</a:t>
            </a:r>
            <a:endParaRPr lang="en-US" dirty="0"/>
          </a:p>
        </p:txBody>
      </p:sp>
      <p:sp>
        <p:nvSpPr>
          <p:cNvPr id="11" name="Left Brace 10"/>
          <p:cNvSpPr/>
          <p:nvPr/>
        </p:nvSpPr>
        <p:spPr>
          <a:xfrm>
            <a:off x="1205563" y="1151385"/>
            <a:ext cx="45719" cy="857889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Left Brace 11"/>
          <p:cNvSpPr/>
          <p:nvPr/>
        </p:nvSpPr>
        <p:spPr>
          <a:xfrm>
            <a:off x="1190224" y="2362748"/>
            <a:ext cx="45719" cy="857889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Left Brace 12"/>
          <p:cNvSpPr/>
          <p:nvPr/>
        </p:nvSpPr>
        <p:spPr>
          <a:xfrm>
            <a:off x="1182703" y="3594600"/>
            <a:ext cx="45719" cy="857889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Left Brace 13"/>
          <p:cNvSpPr/>
          <p:nvPr/>
        </p:nvSpPr>
        <p:spPr>
          <a:xfrm>
            <a:off x="1118335" y="830123"/>
            <a:ext cx="128735" cy="237208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/>
          <p:cNvSpPr txBox="1"/>
          <p:nvPr/>
        </p:nvSpPr>
        <p:spPr>
          <a:xfrm>
            <a:off x="654712" y="5500505"/>
            <a:ext cx="2045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W</a:t>
            </a:r>
            <a:endParaRPr 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20048" y="6096013"/>
            <a:ext cx="11670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smooth</a:t>
            </a:r>
            <a:endParaRPr 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-1008" y="7309972"/>
            <a:ext cx="120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minimal</a:t>
            </a:r>
            <a:endParaRPr lang="en-US" dirty="0"/>
          </a:p>
        </p:txBody>
      </p:sp>
      <p:sp>
        <p:nvSpPr>
          <p:cNvPr id="18" name="TextBox 17"/>
          <p:cNvSpPr txBox="1"/>
          <p:nvPr/>
        </p:nvSpPr>
        <p:spPr>
          <a:xfrm>
            <a:off x="38094" y="8575323"/>
            <a:ext cx="12332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initial</a:t>
            </a:r>
            <a:endParaRPr lang="en-US" dirty="0"/>
          </a:p>
        </p:txBody>
      </p:sp>
      <p:sp>
        <p:nvSpPr>
          <p:cNvPr id="19" name="Left Brace 18"/>
          <p:cNvSpPr/>
          <p:nvPr/>
        </p:nvSpPr>
        <p:spPr>
          <a:xfrm>
            <a:off x="1225611" y="5887829"/>
            <a:ext cx="45719" cy="857889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Left Brace 19"/>
          <p:cNvSpPr/>
          <p:nvPr/>
        </p:nvSpPr>
        <p:spPr>
          <a:xfrm>
            <a:off x="1210272" y="7099192"/>
            <a:ext cx="45719" cy="857889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Left Brace 20"/>
          <p:cNvSpPr/>
          <p:nvPr/>
        </p:nvSpPr>
        <p:spPr>
          <a:xfrm>
            <a:off x="1202751" y="8331044"/>
            <a:ext cx="45719" cy="857889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Left Brace 21"/>
          <p:cNvSpPr/>
          <p:nvPr/>
        </p:nvSpPr>
        <p:spPr>
          <a:xfrm>
            <a:off x="1138383" y="5566567"/>
            <a:ext cx="128735" cy="237208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TextBox 22"/>
          <p:cNvSpPr txBox="1"/>
          <p:nvPr/>
        </p:nvSpPr>
        <p:spPr>
          <a:xfrm>
            <a:off x="1820964" y="4772204"/>
            <a:ext cx="3609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W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2430378" y="4772204"/>
            <a:ext cx="12753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smooth</a:t>
            </a:r>
            <a:endParaRPr lang="en-US" dirty="0"/>
          </a:p>
        </p:txBody>
      </p:sp>
      <p:sp>
        <p:nvSpPr>
          <p:cNvPr id="25" name="TextBox 24"/>
          <p:cNvSpPr txBox="1"/>
          <p:nvPr/>
        </p:nvSpPr>
        <p:spPr>
          <a:xfrm>
            <a:off x="4018548" y="4772204"/>
            <a:ext cx="1660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minimal</a:t>
            </a:r>
            <a:endParaRPr lang="en-US" dirty="0"/>
          </a:p>
        </p:txBody>
      </p:sp>
      <p:sp>
        <p:nvSpPr>
          <p:cNvPr id="26" name="TextBox 25"/>
          <p:cNvSpPr txBox="1"/>
          <p:nvPr/>
        </p:nvSpPr>
        <p:spPr>
          <a:xfrm>
            <a:off x="5955632" y="4772204"/>
            <a:ext cx="12272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0 initial</a:t>
            </a:r>
            <a:endParaRPr lang="en-US" dirty="0"/>
          </a:p>
        </p:txBody>
      </p:sp>
      <p:sp>
        <p:nvSpPr>
          <p:cNvPr id="27" name="Left Brace 26"/>
          <p:cNvSpPr/>
          <p:nvPr/>
        </p:nvSpPr>
        <p:spPr>
          <a:xfrm rot="16200000">
            <a:off x="1991373" y="4584235"/>
            <a:ext cx="60740" cy="330433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Left Brace 27"/>
          <p:cNvSpPr/>
          <p:nvPr/>
        </p:nvSpPr>
        <p:spPr>
          <a:xfrm rot="5400000">
            <a:off x="1982765" y="4944369"/>
            <a:ext cx="63902" cy="330433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Left Brace 28"/>
          <p:cNvSpPr/>
          <p:nvPr/>
        </p:nvSpPr>
        <p:spPr>
          <a:xfrm rot="16200000">
            <a:off x="2980415" y="4278007"/>
            <a:ext cx="45719" cy="1025474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Left Brace 29"/>
          <p:cNvSpPr/>
          <p:nvPr/>
        </p:nvSpPr>
        <p:spPr>
          <a:xfrm rot="16200000">
            <a:off x="4665702" y="4085871"/>
            <a:ext cx="53230" cy="1419731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Left Brace 30"/>
          <p:cNvSpPr/>
          <p:nvPr/>
        </p:nvSpPr>
        <p:spPr>
          <a:xfrm rot="16200000">
            <a:off x="6546384" y="4185881"/>
            <a:ext cx="45720" cy="1227223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Left Brace 31"/>
          <p:cNvSpPr/>
          <p:nvPr/>
        </p:nvSpPr>
        <p:spPr>
          <a:xfrm rot="5400000">
            <a:off x="2975723" y="4601249"/>
            <a:ext cx="55102" cy="1025475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Left Brace 32"/>
          <p:cNvSpPr/>
          <p:nvPr/>
        </p:nvSpPr>
        <p:spPr>
          <a:xfrm rot="5400000">
            <a:off x="4644160" y="4429680"/>
            <a:ext cx="96314" cy="1419732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Left Brace 33"/>
          <p:cNvSpPr/>
          <p:nvPr/>
        </p:nvSpPr>
        <p:spPr>
          <a:xfrm rot="5400000">
            <a:off x="6562216" y="4520901"/>
            <a:ext cx="50148" cy="1191123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TextBox 34"/>
          <p:cNvSpPr txBox="1"/>
          <p:nvPr/>
        </p:nvSpPr>
        <p:spPr>
          <a:xfrm>
            <a:off x="963169" y="9607296"/>
            <a:ext cx="65926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olored boxes indicate significant differences by </a:t>
            </a:r>
            <a:r>
              <a:rPr lang="en-US" dirty="0" err="1" smtClean="0"/>
              <a:t>Kruskal</a:t>
            </a:r>
            <a:r>
              <a:rPr lang="en-US" dirty="0" smtClean="0"/>
              <a:t>-Wallis test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772584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5</TotalTime>
  <Words>1859</Words>
  <Application>Microsoft Office PowerPoint</Application>
  <PresentationFormat>Custom</PresentationFormat>
  <Paragraphs>1055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Kentuck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rnet, Austin D.</dc:creator>
  <cp:lastModifiedBy>Gornet, Austin D.</cp:lastModifiedBy>
  <cp:revision>22</cp:revision>
  <dcterms:created xsi:type="dcterms:W3CDTF">2020-10-01T11:27:34Z</dcterms:created>
  <dcterms:modified xsi:type="dcterms:W3CDTF">2021-03-16T15:58:41Z</dcterms:modified>
</cp:coreProperties>
</file>